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wdp" ContentType="image/vnd.ms-photo"/>
  <Default Extension="tif" ContentType="image/tiff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07" r:id="rId2"/>
    <p:sldId id="309" r:id="rId3"/>
    <p:sldId id="303" r:id="rId4"/>
    <p:sldId id="300" r:id="rId5"/>
    <p:sldId id="310" r:id="rId6"/>
    <p:sldId id="308" r:id="rId7"/>
    <p:sldId id="304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31" userDrawn="1">
          <p15:clr>
            <a:srgbClr val="A4A3A4"/>
          </p15:clr>
        </p15:guide>
        <p15:guide id="2" pos="25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85D8A"/>
    <a:srgbClr val="7433F7"/>
    <a:srgbClr val="008000"/>
    <a:srgbClr val="63D71E"/>
    <a:srgbClr val="85D026"/>
    <a:srgbClr val="5BD025"/>
    <a:srgbClr val="9BD05C"/>
    <a:srgbClr val="FF9450"/>
    <a:srgbClr val="3D30FF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854" autoAdjust="0"/>
    <p:restoredTop sz="50000" autoAdjust="0"/>
  </p:normalViewPr>
  <p:slideViewPr>
    <p:cSldViewPr>
      <p:cViewPr varScale="1">
        <p:scale>
          <a:sx n="109" d="100"/>
          <a:sy n="109" d="100"/>
        </p:scale>
        <p:origin x="426" y="96"/>
      </p:cViewPr>
      <p:guideLst>
        <p:guide orient="horz" pos="731"/>
        <p:guide pos="25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veronica:Desktop:progetti%20giugno%202016:MICROCEFALIA%20giugno%202016:polimerizzazione%20microtubuli%2027_4_16%20ripetuta%20con%20prune%20tris%206.9:27APRILEpRUNEwt%20exce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5742627759765"/>
          <c:y val="0.185178546760602"/>
          <c:w val="0.41082960218207998"/>
          <c:h val="0.45543548832711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Foglio5!$B$2</c:f>
              <c:strCache>
                <c:ptCount val="1"/>
                <c:pt idx="0">
                  <c:v> MT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xVal>
            <c:numRef>
              <c:f>Foglio5!$A$3:$A$83</c:f>
              <c:numCache>
                <c:formatCode>General</c:formatCode>
                <c:ptCount val="8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  <c:pt idx="21">
                  <c:v>630</c:v>
                </c:pt>
                <c:pt idx="22">
                  <c:v>660</c:v>
                </c:pt>
                <c:pt idx="23">
                  <c:v>690</c:v>
                </c:pt>
                <c:pt idx="24">
                  <c:v>720</c:v>
                </c:pt>
                <c:pt idx="25">
                  <c:v>750</c:v>
                </c:pt>
                <c:pt idx="26">
                  <c:v>780</c:v>
                </c:pt>
                <c:pt idx="27">
                  <c:v>810</c:v>
                </c:pt>
                <c:pt idx="28">
                  <c:v>840</c:v>
                </c:pt>
                <c:pt idx="29">
                  <c:v>870</c:v>
                </c:pt>
                <c:pt idx="30">
                  <c:v>900</c:v>
                </c:pt>
                <c:pt idx="31">
                  <c:v>930</c:v>
                </c:pt>
                <c:pt idx="32">
                  <c:v>960</c:v>
                </c:pt>
                <c:pt idx="33">
                  <c:v>990</c:v>
                </c:pt>
                <c:pt idx="34">
                  <c:v>1020</c:v>
                </c:pt>
                <c:pt idx="35">
                  <c:v>1050</c:v>
                </c:pt>
                <c:pt idx="36">
                  <c:v>1080</c:v>
                </c:pt>
                <c:pt idx="37">
                  <c:v>1110</c:v>
                </c:pt>
                <c:pt idx="38">
                  <c:v>1140</c:v>
                </c:pt>
                <c:pt idx="39">
                  <c:v>1170</c:v>
                </c:pt>
                <c:pt idx="40">
                  <c:v>1200</c:v>
                </c:pt>
                <c:pt idx="41">
                  <c:v>1230</c:v>
                </c:pt>
                <c:pt idx="42">
                  <c:v>1260</c:v>
                </c:pt>
                <c:pt idx="43">
                  <c:v>1290</c:v>
                </c:pt>
                <c:pt idx="44">
                  <c:v>1320</c:v>
                </c:pt>
                <c:pt idx="45">
                  <c:v>1350</c:v>
                </c:pt>
                <c:pt idx="46">
                  <c:v>1380</c:v>
                </c:pt>
                <c:pt idx="47">
                  <c:v>1410</c:v>
                </c:pt>
                <c:pt idx="48">
                  <c:v>1440</c:v>
                </c:pt>
                <c:pt idx="49">
                  <c:v>1470</c:v>
                </c:pt>
                <c:pt idx="50">
                  <c:v>1500</c:v>
                </c:pt>
                <c:pt idx="51">
                  <c:v>1530</c:v>
                </c:pt>
                <c:pt idx="52">
                  <c:v>1560</c:v>
                </c:pt>
                <c:pt idx="53">
                  <c:v>1590</c:v>
                </c:pt>
                <c:pt idx="54">
                  <c:v>1620</c:v>
                </c:pt>
                <c:pt idx="55">
                  <c:v>1650</c:v>
                </c:pt>
                <c:pt idx="56">
                  <c:v>1680</c:v>
                </c:pt>
                <c:pt idx="57">
                  <c:v>1710</c:v>
                </c:pt>
                <c:pt idx="58">
                  <c:v>1740</c:v>
                </c:pt>
                <c:pt idx="59">
                  <c:v>1770</c:v>
                </c:pt>
                <c:pt idx="60">
                  <c:v>1800</c:v>
                </c:pt>
                <c:pt idx="61">
                  <c:v>1830</c:v>
                </c:pt>
                <c:pt idx="62">
                  <c:v>1860</c:v>
                </c:pt>
                <c:pt idx="63">
                  <c:v>1890</c:v>
                </c:pt>
                <c:pt idx="64">
                  <c:v>1920</c:v>
                </c:pt>
                <c:pt idx="65">
                  <c:v>1950</c:v>
                </c:pt>
                <c:pt idx="66">
                  <c:v>1980</c:v>
                </c:pt>
                <c:pt idx="67">
                  <c:v>2010</c:v>
                </c:pt>
                <c:pt idx="68">
                  <c:v>2040</c:v>
                </c:pt>
                <c:pt idx="69">
                  <c:v>2070</c:v>
                </c:pt>
                <c:pt idx="70">
                  <c:v>2100</c:v>
                </c:pt>
                <c:pt idx="71">
                  <c:v>2130</c:v>
                </c:pt>
                <c:pt idx="72">
                  <c:v>2160</c:v>
                </c:pt>
                <c:pt idx="73">
                  <c:v>2190</c:v>
                </c:pt>
                <c:pt idx="74">
                  <c:v>2220</c:v>
                </c:pt>
                <c:pt idx="75">
                  <c:v>2250</c:v>
                </c:pt>
                <c:pt idx="76">
                  <c:v>2280</c:v>
                </c:pt>
                <c:pt idx="77">
                  <c:v>2310</c:v>
                </c:pt>
                <c:pt idx="78">
                  <c:v>2340</c:v>
                </c:pt>
                <c:pt idx="79">
                  <c:v>2370</c:v>
                </c:pt>
                <c:pt idx="80">
                  <c:v>2400</c:v>
                </c:pt>
              </c:numCache>
            </c:numRef>
          </c:xVal>
          <c:yVal>
            <c:numRef>
              <c:f>Foglio5!$B$3:$B$83</c:f>
              <c:numCache>
                <c:formatCode>General</c:formatCode>
                <c:ptCount val="81"/>
                <c:pt idx="0">
                  <c:v>4709.5</c:v>
                </c:pt>
                <c:pt idx="1">
                  <c:v>8959</c:v>
                </c:pt>
                <c:pt idx="2">
                  <c:v>8844</c:v>
                </c:pt>
                <c:pt idx="3">
                  <c:v>8903.5</c:v>
                </c:pt>
                <c:pt idx="4">
                  <c:v>8813</c:v>
                </c:pt>
                <c:pt idx="5">
                  <c:v>9186.5</c:v>
                </c:pt>
                <c:pt idx="6">
                  <c:v>9080.5</c:v>
                </c:pt>
                <c:pt idx="7">
                  <c:v>9078</c:v>
                </c:pt>
                <c:pt idx="8">
                  <c:v>9413</c:v>
                </c:pt>
                <c:pt idx="9">
                  <c:v>9618</c:v>
                </c:pt>
                <c:pt idx="10">
                  <c:v>9945.5</c:v>
                </c:pt>
                <c:pt idx="11">
                  <c:v>10256.5</c:v>
                </c:pt>
                <c:pt idx="12">
                  <c:v>10744.5</c:v>
                </c:pt>
                <c:pt idx="13">
                  <c:v>11203</c:v>
                </c:pt>
                <c:pt idx="14">
                  <c:v>11997.5</c:v>
                </c:pt>
                <c:pt idx="15">
                  <c:v>12595.5</c:v>
                </c:pt>
                <c:pt idx="16">
                  <c:v>13238</c:v>
                </c:pt>
                <c:pt idx="17">
                  <c:v>14172</c:v>
                </c:pt>
                <c:pt idx="18">
                  <c:v>14792</c:v>
                </c:pt>
                <c:pt idx="19">
                  <c:v>15501</c:v>
                </c:pt>
                <c:pt idx="20">
                  <c:v>16263</c:v>
                </c:pt>
                <c:pt idx="21">
                  <c:v>17086.5</c:v>
                </c:pt>
                <c:pt idx="22">
                  <c:v>17845.5</c:v>
                </c:pt>
                <c:pt idx="23">
                  <c:v>18804.5</c:v>
                </c:pt>
                <c:pt idx="24">
                  <c:v>19480.5</c:v>
                </c:pt>
                <c:pt idx="25">
                  <c:v>19938.5</c:v>
                </c:pt>
                <c:pt idx="26">
                  <c:v>20572</c:v>
                </c:pt>
                <c:pt idx="27">
                  <c:v>21345</c:v>
                </c:pt>
                <c:pt idx="28">
                  <c:v>22049</c:v>
                </c:pt>
                <c:pt idx="29">
                  <c:v>22631</c:v>
                </c:pt>
                <c:pt idx="30">
                  <c:v>23122.5</c:v>
                </c:pt>
                <c:pt idx="31">
                  <c:v>23750.5</c:v>
                </c:pt>
                <c:pt idx="32">
                  <c:v>24093</c:v>
                </c:pt>
                <c:pt idx="33">
                  <c:v>24478</c:v>
                </c:pt>
                <c:pt idx="34">
                  <c:v>24838.5</c:v>
                </c:pt>
                <c:pt idx="35">
                  <c:v>25314</c:v>
                </c:pt>
                <c:pt idx="36">
                  <c:v>25472.5</c:v>
                </c:pt>
                <c:pt idx="37">
                  <c:v>26147.5</c:v>
                </c:pt>
                <c:pt idx="38">
                  <c:v>26395.5</c:v>
                </c:pt>
                <c:pt idx="39">
                  <c:v>26480.5</c:v>
                </c:pt>
                <c:pt idx="40">
                  <c:v>26881.5</c:v>
                </c:pt>
                <c:pt idx="41">
                  <c:v>27042.5</c:v>
                </c:pt>
                <c:pt idx="42">
                  <c:v>27195</c:v>
                </c:pt>
                <c:pt idx="43">
                  <c:v>27376</c:v>
                </c:pt>
                <c:pt idx="44">
                  <c:v>27709.5</c:v>
                </c:pt>
                <c:pt idx="45">
                  <c:v>27742.5</c:v>
                </c:pt>
                <c:pt idx="46">
                  <c:v>28011.5</c:v>
                </c:pt>
                <c:pt idx="47">
                  <c:v>28092</c:v>
                </c:pt>
                <c:pt idx="48">
                  <c:v>28239</c:v>
                </c:pt>
                <c:pt idx="49">
                  <c:v>28405</c:v>
                </c:pt>
                <c:pt idx="50">
                  <c:v>28478.5</c:v>
                </c:pt>
                <c:pt idx="51">
                  <c:v>28499</c:v>
                </c:pt>
                <c:pt idx="52">
                  <c:v>28640.5</c:v>
                </c:pt>
                <c:pt idx="53">
                  <c:v>28619</c:v>
                </c:pt>
                <c:pt idx="54">
                  <c:v>28854</c:v>
                </c:pt>
                <c:pt idx="55">
                  <c:v>28917.5</c:v>
                </c:pt>
                <c:pt idx="56">
                  <c:v>29006</c:v>
                </c:pt>
                <c:pt idx="57">
                  <c:v>28896.5</c:v>
                </c:pt>
                <c:pt idx="58">
                  <c:v>28985</c:v>
                </c:pt>
                <c:pt idx="59">
                  <c:v>29049.5</c:v>
                </c:pt>
                <c:pt idx="60">
                  <c:v>29181</c:v>
                </c:pt>
                <c:pt idx="61">
                  <c:v>29172</c:v>
                </c:pt>
                <c:pt idx="62">
                  <c:v>29101.5</c:v>
                </c:pt>
                <c:pt idx="63">
                  <c:v>29367</c:v>
                </c:pt>
                <c:pt idx="64">
                  <c:v>29245.5</c:v>
                </c:pt>
                <c:pt idx="65">
                  <c:v>29154</c:v>
                </c:pt>
                <c:pt idx="66">
                  <c:v>29092</c:v>
                </c:pt>
                <c:pt idx="67">
                  <c:v>29199.5</c:v>
                </c:pt>
                <c:pt idx="68">
                  <c:v>29137</c:v>
                </c:pt>
                <c:pt idx="69">
                  <c:v>29234.5</c:v>
                </c:pt>
                <c:pt idx="70">
                  <c:v>29240.5</c:v>
                </c:pt>
                <c:pt idx="71">
                  <c:v>29190</c:v>
                </c:pt>
                <c:pt idx="72">
                  <c:v>29245</c:v>
                </c:pt>
                <c:pt idx="73">
                  <c:v>29140.5</c:v>
                </c:pt>
                <c:pt idx="74">
                  <c:v>29019</c:v>
                </c:pt>
                <c:pt idx="75">
                  <c:v>28990.5</c:v>
                </c:pt>
                <c:pt idx="76">
                  <c:v>29132.5</c:v>
                </c:pt>
                <c:pt idx="77">
                  <c:v>29023.5</c:v>
                </c:pt>
                <c:pt idx="78">
                  <c:v>29044.5</c:v>
                </c:pt>
                <c:pt idx="79">
                  <c:v>28919</c:v>
                </c:pt>
                <c:pt idx="80">
                  <c:v>2902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9D57-4078-96E2-30C5D73D89C1}"/>
            </c:ext>
          </c:extLst>
        </c:ser>
        <c:ser>
          <c:idx val="1"/>
          <c:order val="1"/>
          <c:tx>
            <c:strRef>
              <c:f>Foglio5!$C$2</c:f>
              <c:strCache>
                <c:ptCount val="1"/>
                <c:pt idx="0">
                  <c:v>MT + 3μM Paclitaxel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Foglio5!$A$3:$A$83</c:f>
              <c:numCache>
                <c:formatCode>General</c:formatCode>
                <c:ptCount val="8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  <c:pt idx="21">
                  <c:v>630</c:v>
                </c:pt>
                <c:pt idx="22">
                  <c:v>660</c:v>
                </c:pt>
                <c:pt idx="23">
                  <c:v>690</c:v>
                </c:pt>
                <c:pt idx="24">
                  <c:v>720</c:v>
                </c:pt>
                <c:pt idx="25">
                  <c:v>750</c:v>
                </c:pt>
                <c:pt idx="26">
                  <c:v>780</c:v>
                </c:pt>
                <c:pt idx="27">
                  <c:v>810</c:v>
                </c:pt>
                <c:pt idx="28">
                  <c:v>840</c:v>
                </c:pt>
                <c:pt idx="29">
                  <c:v>870</c:v>
                </c:pt>
                <c:pt idx="30">
                  <c:v>900</c:v>
                </c:pt>
                <c:pt idx="31">
                  <c:v>930</c:v>
                </c:pt>
                <c:pt idx="32">
                  <c:v>960</c:v>
                </c:pt>
                <c:pt idx="33">
                  <c:v>990</c:v>
                </c:pt>
                <c:pt idx="34">
                  <c:v>1020</c:v>
                </c:pt>
                <c:pt idx="35">
                  <c:v>1050</c:v>
                </c:pt>
                <c:pt idx="36">
                  <c:v>1080</c:v>
                </c:pt>
                <c:pt idx="37">
                  <c:v>1110</c:v>
                </c:pt>
                <c:pt idx="38">
                  <c:v>1140</c:v>
                </c:pt>
                <c:pt idx="39">
                  <c:v>1170</c:v>
                </c:pt>
                <c:pt idx="40">
                  <c:v>1200</c:v>
                </c:pt>
                <c:pt idx="41">
                  <c:v>1230</c:v>
                </c:pt>
                <c:pt idx="42">
                  <c:v>1260</c:v>
                </c:pt>
                <c:pt idx="43">
                  <c:v>1290</c:v>
                </c:pt>
                <c:pt idx="44">
                  <c:v>1320</c:v>
                </c:pt>
                <c:pt idx="45">
                  <c:v>1350</c:v>
                </c:pt>
                <c:pt idx="46">
                  <c:v>1380</c:v>
                </c:pt>
                <c:pt idx="47">
                  <c:v>1410</c:v>
                </c:pt>
                <c:pt idx="48">
                  <c:v>1440</c:v>
                </c:pt>
                <c:pt idx="49">
                  <c:v>1470</c:v>
                </c:pt>
                <c:pt idx="50">
                  <c:v>1500</c:v>
                </c:pt>
                <c:pt idx="51">
                  <c:v>1530</c:v>
                </c:pt>
                <c:pt idx="52">
                  <c:v>1560</c:v>
                </c:pt>
                <c:pt idx="53">
                  <c:v>1590</c:v>
                </c:pt>
                <c:pt idx="54">
                  <c:v>1620</c:v>
                </c:pt>
                <c:pt idx="55">
                  <c:v>1650</c:v>
                </c:pt>
                <c:pt idx="56">
                  <c:v>1680</c:v>
                </c:pt>
                <c:pt idx="57">
                  <c:v>1710</c:v>
                </c:pt>
                <c:pt idx="58">
                  <c:v>1740</c:v>
                </c:pt>
                <c:pt idx="59">
                  <c:v>1770</c:v>
                </c:pt>
                <c:pt idx="60">
                  <c:v>1800</c:v>
                </c:pt>
                <c:pt idx="61">
                  <c:v>1830</c:v>
                </c:pt>
                <c:pt idx="62">
                  <c:v>1860</c:v>
                </c:pt>
                <c:pt idx="63">
                  <c:v>1890</c:v>
                </c:pt>
                <c:pt idx="64">
                  <c:v>1920</c:v>
                </c:pt>
                <c:pt idx="65">
                  <c:v>1950</c:v>
                </c:pt>
                <c:pt idx="66">
                  <c:v>1980</c:v>
                </c:pt>
                <c:pt idx="67">
                  <c:v>2010</c:v>
                </c:pt>
                <c:pt idx="68">
                  <c:v>2040</c:v>
                </c:pt>
                <c:pt idx="69">
                  <c:v>2070</c:v>
                </c:pt>
                <c:pt idx="70">
                  <c:v>2100</c:v>
                </c:pt>
                <c:pt idx="71">
                  <c:v>2130</c:v>
                </c:pt>
                <c:pt idx="72">
                  <c:v>2160</c:v>
                </c:pt>
                <c:pt idx="73">
                  <c:v>2190</c:v>
                </c:pt>
                <c:pt idx="74">
                  <c:v>2220</c:v>
                </c:pt>
                <c:pt idx="75">
                  <c:v>2250</c:v>
                </c:pt>
                <c:pt idx="76">
                  <c:v>2280</c:v>
                </c:pt>
                <c:pt idx="77">
                  <c:v>2310</c:v>
                </c:pt>
                <c:pt idx="78">
                  <c:v>2340</c:v>
                </c:pt>
                <c:pt idx="79">
                  <c:v>2370</c:v>
                </c:pt>
                <c:pt idx="80">
                  <c:v>2400</c:v>
                </c:pt>
              </c:numCache>
            </c:numRef>
          </c:xVal>
          <c:yVal>
            <c:numRef>
              <c:f>Foglio5!$C$3:$C$83</c:f>
              <c:numCache>
                <c:formatCode>General</c:formatCode>
                <c:ptCount val="81"/>
                <c:pt idx="0">
                  <c:v>7264</c:v>
                </c:pt>
                <c:pt idx="1">
                  <c:v>16042</c:v>
                </c:pt>
                <c:pt idx="2">
                  <c:v>18474</c:v>
                </c:pt>
                <c:pt idx="3">
                  <c:v>20761</c:v>
                </c:pt>
                <c:pt idx="4">
                  <c:v>23297</c:v>
                </c:pt>
                <c:pt idx="5">
                  <c:v>25346</c:v>
                </c:pt>
                <c:pt idx="6">
                  <c:v>27441</c:v>
                </c:pt>
                <c:pt idx="7">
                  <c:v>29340</c:v>
                </c:pt>
                <c:pt idx="8">
                  <c:v>30628</c:v>
                </c:pt>
                <c:pt idx="9">
                  <c:v>31799</c:v>
                </c:pt>
                <c:pt idx="10">
                  <c:v>32988</c:v>
                </c:pt>
                <c:pt idx="11">
                  <c:v>33717</c:v>
                </c:pt>
                <c:pt idx="12">
                  <c:v>34553</c:v>
                </c:pt>
                <c:pt idx="13">
                  <c:v>35185</c:v>
                </c:pt>
                <c:pt idx="14">
                  <c:v>35696</c:v>
                </c:pt>
                <c:pt idx="15">
                  <c:v>36173</c:v>
                </c:pt>
                <c:pt idx="16">
                  <c:v>36386</c:v>
                </c:pt>
                <c:pt idx="17">
                  <c:v>36887</c:v>
                </c:pt>
                <c:pt idx="18">
                  <c:v>37302</c:v>
                </c:pt>
                <c:pt idx="19">
                  <c:v>37541</c:v>
                </c:pt>
                <c:pt idx="20">
                  <c:v>37505</c:v>
                </c:pt>
                <c:pt idx="21">
                  <c:v>37496</c:v>
                </c:pt>
                <c:pt idx="22">
                  <c:v>37728</c:v>
                </c:pt>
                <c:pt idx="23">
                  <c:v>37862</c:v>
                </c:pt>
                <c:pt idx="24">
                  <c:v>37914</c:v>
                </c:pt>
                <c:pt idx="25">
                  <c:v>37930</c:v>
                </c:pt>
                <c:pt idx="26">
                  <c:v>38101</c:v>
                </c:pt>
                <c:pt idx="27">
                  <c:v>37876</c:v>
                </c:pt>
                <c:pt idx="28">
                  <c:v>37990</c:v>
                </c:pt>
                <c:pt idx="29">
                  <c:v>38123</c:v>
                </c:pt>
                <c:pt idx="30">
                  <c:v>38080</c:v>
                </c:pt>
                <c:pt idx="31">
                  <c:v>38150</c:v>
                </c:pt>
                <c:pt idx="32">
                  <c:v>38234</c:v>
                </c:pt>
                <c:pt idx="33">
                  <c:v>37975</c:v>
                </c:pt>
                <c:pt idx="34">
                  <c:v>38104</c:v>
                </c:pt>
                <c:pt idx="35">
                  <c:v>38042</c:v>
                </c:pt>
                <c:pt idx="36">
                  <c:v>38015</c:v>
                </c:pt>
                <c:pt idx="37">
                  <c:v>38103</c:v>
                </c:pt>
                <c:pt idx="38">
                  <c:v>38034</c:v>
                </c:pt>
                <c:pt idx="39">
                  <c:v>37963</c:v>
                </c:pt>
                <c:pt idx="40">
                  <c:v>38066</c:v>
                </c:pt>
                <c:pt idx="41">
                  <c:v>38174</c:v>
                </c:pt>
                <c:pt idx="42">
                  <c:v>37747</c:v>
                </c:pt>
                <c:pt idx="43">
                  <c:v>37827</c:v>
                </c:pt>
                <c:pt idx="44">
                  <c:v>37630</c:v>
                </c:pt>
                <c:pt idx="45">
                  <c:v>37648</c:v>
                </c:pt>
                <c:pt idx="46">
                  <c:v>37717</c:v>
                </c:pt>
                <c:pt idx="47">
                  <c:v>37717</c:v>
                </c:pt>
                <c:pt idx="48">
                  <c:v>37830</c:v>
                </c:pt>
                <c:pt idx="49">
                  <c:v>37649</c:v>
                </c:pt>
                <c:pt idx="50">
                  <c:v>37885</c:v>
                </c:pt>
                <c:pt idx="51">
                  <c:v>37532</c:v>
                </c:pt>
                <c:pt idx="52">
                  <c:v>37602</c:v>
                </c:pt>
                <c:pt idx="53">
                  <c:v>37437</c:v>
                </c:pt>
                <c:pt idx="54">
                  <c:v>37621</c:v>
                </c:pt>
                <c:pt idx="55">
                  <c:v>37437</c:v>
                </c:pt>
                <c:pt idx="56">
                  <c:v>37508</c:v>
                </c:pt>
                <c:pt idx="57">
                  <c:v>37451</c:v>
                </c:pt>
                <c:pt idx="58">
                  <c:v>37137</c:v>
                </c:pt>
                <c:pt idx="59">
                  <c:v>37052</c:v>
                </c:pt>
                <c:pt idx="60">
                  <c:v>37034</c:v>
                </c:pt>
                <c:pt idx="61">
                  <c:v>37034</c:v>
                </c:pt>
                <c:pt idx="62">
                  <c:v>36687</c:v>
                </c:pt>
                <c:pt idx="63">
                  <c:v>36796</c:v>
                </c:pt>
                <c:pt idx="64">
                  <c:v>36771</c:v>
                </c:pt>
                <c:pt idx="65">
                  <c:v>36614</c:v>
                </c:pt>
                <c:pt idx="66">
                  <c:v>36640</c:v>
                </c:pt>
                <c:pt idx="67">
                  <c:v>36351</c:v>
                </c:pt>
                <c:pt idx="68">
                  <c:v>36351</c:v>
                </c:pt>
                <c:pt idx="69">
                  <c:v>36564</c:v>
                </c:pt>
                <c:pt idx="70">
                  <c:v>35893</c:v>
                </c:pt>
                <c:pt idx="71">
                  <c:v>36309</c:v>
                </c:pt>
                <c:pt idx="72">
                  <c:v>36182</c:v>
                </c:pt>
                <c:pt idx="73">
                  <c:v>36040</c:v>
                </c:pt>
                <c:pt idx="74">
                  <c:v>36302</c:v>
                </c:pt>
                <c:pt idx="75">
                  <c:v>36011</c:v>
                </c:pt>
                <c:pt idx="76">
                  <c:v>35707</c:v>
                </c:pt>
                <c:pt idx="77">
                  <c:v>35683</c:v>
                </c:pt>
                <c:pt idx="78">
                  <c:v>35766</c:v>
                </c:pt>
                <c:pt idx="79">
                  <c:v>35779</c:v>
                </c:pt>
                <c:pt idx="80">
                  <c:v>3549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9D57-4078-96E2-30C5D73D89C1}"/>
            </c:ext>
          </c:extLst>
        </c:ser>
        <c:ser>
          <c:idx val="2"/>
          <c:order val="2"/>
          <c:tx>
            <c:strRef>
              <c:f>Foglio5!$D$2</c:f>
              <c:strCache>
                <c:ptCount val="1"/>
                <c:pt idx="0">
                  <c:v> MT + 3μM Nocodazole</c:v>
                </c:pt>
              </c:strCache>
            </c:strRef>
          </c:tx>
          <c:spPr>
            <a:ln>
              <a:solidFill>
                <a:srgbClr val="008000"/>
              </a:solidFill>
            </a:ln>
          </c:spPr>
          <c:marker>
            <c:symbol val="none"/>
          </c:marker>
          <c:xVal>
            <c:numRef>
              <c:f>Foglio5!$A$3:$A$83</c:f>
              <c:numCache>
                <c:formatCode>General</c:formatCode>
                <c:ptCount val="8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  <c:pt idx="21">
                  <c:v>630</c:v>
                </c:pt>
                <c:pt idx="22">
                  <c:v>660</c:v>
                </c:pt>
                <c:pt idx="23">
                  <c:v>690</c:v>
                </c:pt>
                <c:pt idx="24">
                  <c:v>720</c:v>
                </c:pt>
                <c:pt idx="25">
                  <c:v>750</c:v>
                </c:pt>
                <c:pt idx="26">
                  <c:v>780</c:v>
                </c:pt>
                <c:pt idx="27">
                  <c:v>810</c:v>
                </c:pt>
                <c:pt idx="28">
                  <c:v>840</c:v>
                </c:pt>
                <c:pt idx="29">
                  <c:v>870</c:v>
                </c:pt>
                <c:pt idx="30">
                  <c:v>900</c:v>
                </c:pt>
                <c:pt idx="31">
                  <c:v>930</c:v>
                </c:pt>
                <c:pt idx="32">
                  <c:v>960</c:v>
                </c:pt>
                <c:pt idx="33">
                  <c:v>990</c:v>
                </c:pt>
                <c:pt idx="34">
                  <c:v>1020</c:v>
                </c:pt>
                <c:pt idx="35">
                  <c:v>1050</c:v>
                </c:pt>
                <c:pt idx="36">
                  <c:v>1080</c:v>
                </c:pt>
                <c:pt idx="37">
                  <c:v>1110</c:v>
                </c:pt>
                <c:pt idx="38">
                  <c:v>1140</c:v>
                </c:pt>
                <c:pt idx="39">
                  <c:v>1170</c:v>
                </c:pt>
                <c:pt idx="40">
                  <c:v>1200</c:v>
                </c:pt>
                <c:pt idx="41">
                  <c:v>1230</c:v>
                </c:pt>
                <c:pt idx="42">
                  <c:v>1260</c:v>
                </c:pt>
                <c:pt idx="43">
                  <c:v>1290</c:v>
                </c:pt>
                <c:pt idx="44">
                  <c:v>1320</c:v>
                </c:pt>
                <c:pt idx="45">
                  <c:v>1350</c:v>
                </c:pt>
                <c:pt idx="46">
                  <c:v>1380</c:v>
                </c:pt>
                <c:pt idx="47">
                  <c:v>1410</c:v>
                </c:pt>
                <c:pt idx="48">
                  <c:v>1440</c:v>
                </c:pt>
                <c:pt idx="49">
                  <c:v>1470</c:v>
                </c:pt>
                <c:pt idx="50">
                  <c:v>1500</c:v>
                </c:pt>
                <c:pt idx="51">
                  <c:v>1530</c:v>
                </c:pt>
                <c:pt idx="52">
                  <c:v>1560</c:v>
                </c:pt>
                <c:pt idx="53">
                  <c:v>1590</c:v>
                </c:pt>
                <c:pt idx="54">
                  <c:v>1620</c:v>
                </c:pt>
                <c:pt idx="55">
                  <c:v>1650</c:v>
                </c:pt>
                <c:pt idx="56">
                  <c:v>1680</c:v>
                </c:pt>
                <c:pt idx="57">
                  <c:v>1710</c:v>
                </c:pt>
                <c:pt idx="58">
                  <c:v>1740</c:v>
                </c:pt>
                <c:pt idx="59">
                  <c:v>1770</c:v>
                </c:pt>
                <c:pt idx="60">
                  <c:v>1800</c:v>
                </c:pt>
                <c:pt idx="61">
                  <c:v>1830</c:v>
                </c:pt>
                <c:pt idx="62">
                  <c:v>1860</c:v>
                </c:pt>
                <c:pt idx="63">
                  <c:v>1890</c:v>
                </c:pt>
                <c:pt idx="64">
                  <c:v>1920</c:v>
                </c:pt>
                <c:pt idx="65">
                  <c:v>1950</c:v>
                </c:pt>
                <c:pt idx="66">
                  <c:v>1980</c:v>
                </c:pt>
                <c:pt idx="67">
                  <c:v>2010</c:v>
                </c:pt>
                <c:pt idx="68">
                  <c:v>2040</c:v>
                </c:pt>
                <c:pt idx="69">
                  <c:v>2070</c:v>
                </c:pt>
                <c:pt idx="70">
                  <c:v>2100</c:v>
                </c:pt>
                <c:pt idx="71">
                  <c:v>2130</c:v>
                </c:pt>
                <c:pt idx="72">
                  <c:v>2160</c:v>
                </c:pt>
                <c:pt idx="73">
                  <c:v>2190</c:v>
                </c:pt>
                <c:pt idx="74">
                  <c:v>2220</c:v>
                </c:pt>
                <c:pt idx="75">
                  <c:v>2250</c:v>
                </c:pt>
                <c:pt idx="76">
                  <c:v>2280</c:v>
                </c:pt>
                <c:pt idx="77">
                  <c:v>2310</c:v>
                </c:pt>
                <c:pt idx="78">
                  <c:v>2340</c:v>
                </c:pt>
                <c:pt idx="79">
                  <c:v>2370</c:v>
                </c:pt>
                <c:pt idx="80">
                  <c:v>2400</c:v>
                </c:pt>
              </c:numCache>
            </c:numRef>
          </c:xVal>
          <c:yVal>
            <c:numRef>
              <c:f>Foglio5!$D$3:$D$83</c:f>
              <c:numCache>
                <c:formatCode>General</c:formatCode>
                <c:ptCount val="81"/>
                <c:pt idx="0">
                  <c:v>5849</c:v>
                </c:pt>
                <c:pt idx="1">
                  <c:v>11034</c:v>
                </c:pt>
                <c:pt idx="2">
                  <c:v>10771</c:v>
                </c:pt>
                <c:pt idx="3">
                  <c:v>10419</c:v>
                </c:pt>
                <c:pt idx="4">
                  <c:v>10523</c:v>
                </c:pt>
                <c:pt idx="5">
                  <c:v>10476</c:v>
                </c:pt>
                <c:pt idx="6">
                  <c:v>10252</c:v>
                </c:pt>
                <c:pt idx="7">
                  <c:v>10211</c:v>
                </c:pt>
                <c:pt idx="8">
                  <c:v>10068</c:v>
                </c:pt>
                <c:pt idx="9">
                  <c:v>10521</c:v>
                </c:pt>
                <c:pt idx="10">
                  <c:v>10243</c:v>
                </c:pt>
                <c:pt idx="11">
                  <c:v>10465</c:v>
                </c:pt>
                <c:pt idx="12">
                  <c:v>9832</c:v>
                </c:pt>
                <c:pt idx="13">
                  <c:v>10347</c:v>
                </c:pt>
                <c:pt idx="14">
                  <c:v>9997</c:v>
                </c:pt>
                <c:pt idx="15">
                  <c:v>10125</c:v>
                </c:pt>
                <c:pt idx="16">
                  <c:v>10170</c:v>
                </c:pt>
                <c:pt idx="17">
                  <c:v>10152</c:v>
                </c:pt>
                <c:pt idx="18">
                  <c:v>10608</c:v>
                </c:pt>
                <c:pt idx="19">
                  <c:v>10583</c:v>
                </c:pt>
                <c:pt idx="20">
                  <c:v>10393</c:v>
                </c:pt>
                <c:pt idx="21">
                  <c:v>10568</c:v>
                </c:pt>
                <c:pt idx="22">
                  <c:v>10662</c:v>
                </c:pt>
                <c:pt idx="23">
                  <c:v>10483</c:v>
                </c:pt>
                <c:pt idx="24">
                  <c:v>10904</c:v>
                </c:pt>
                <c:pt idx="25">
                  <c:v>10699</c:v>
                </c:pt>
                <c:pt idx="26">
                  <c:v>10909</c:v>
                </c:pt>
                <c:pt idx="27">
                  <c:v>10692</c:v>
                </c:pt>
                <c:pt idx="28">
                  <c:v>11011</c:v>
                </c:pt>
                <c:pt idx="29">
                  <c:v>11533</c:v>
                </c:pt>
                <c:pt idx="30">
                  <c:v>11401</c:v>
                </c:pt>
                <c:pt idx="31">
                  <c:v>11217</c:v>
                </c:pt>
                <c:pt idx="32">
                  <c:v>11256</c:v>
                </c:pt>
                <c:pt idx="33">
                  <c:v>11594</c:v>
                </c:pt>
                <c:pt idx="34">
                  <c:v>11506</c:v>
                </c:pt>
                <c:pt idx="35">
                  <c:v>11691</c:v>
                </c:pt>
                <c:pt idx="36">
                  <c:v>11919</c:v>
                </c:pt>
                <c:pt idx="37">
                  <c:v>12023</c:v>
                </c:pt>
                <c:pt idx="38">
                  <c:v>12099</c:v>
                </c:pt>
                <c:pt idx="39">
                  <c:v>12294</c:v>
                </c:pt>
                <c:pt idx="40">
                  <c:v>12461</c:v>
                </c:pt>
                <c:pt idx="41">
                  <c:v>12517</c:v>
                </c:pt>
                <c:pt idx="42">
                  <c:v>12706</c:v>
                </c:pt>
                <c:pt idx="43">
                  <c:v>12859</c:v>
                </c:pt>
                <c:pt idx="44">
                  <c:v>13241</c:v>
                </c:pt>
                <c:pt idx="45">
                  <c:v>13525</c:v>
                </c:pt>
                <c:pt idx="46">
                  <c:v>13377</c:v>
                </c:pt>
                <c:pt idx="47">
                  <c:v>13526</c:v>
                </c:pt>
                <c:pt idx="48">
                  <c:v>13828</c:v>
                </c:pt>
                <c:pt idx="49">
                  <c:v>13791</c:v>
                </c:pt>
                <c:pt idx="50">
                  <c:v>14173</c:v>
                </c:pt>
                <c:pt idx="51">
                  <c:v>14170</c:v>
                </c:pt>
                <c:pt idx="52">
                  <c:v>14280</c:v>
                </c:pt>
                <c:pt idx="53">
                  <c:v>14509</c:v>
                </c:pt>
                <c:pt idx="54">
                  <c:v>14732</c:v>
                </c:pt>
                <c:pt idx="55">
                  <c:v>14778</c:v>
                </c:pt>
                <c:pt idx="56">
                  <c:v>14985</c:v>
                </c:pt>
                <c:pt idx="57">
                  <c:v>15190</c:v>
                </c:pt>
                <c:pt idx="58">
                  <c:v>15531</c:v>
                </c:pt>
                <c:pt idx="59">
                  <c:v>15768</c:v>
                </c:pt>
                <c:pt idx="60">
                  <c:v>15536</c:v>
                </c:pt>
                <c:pt idx="61">
                  <c:v>16004</c:v>
                </c:pt>
                <c:pt idx="62">
                  <c:v>16210</c:v>
                </c:pt>
                <c:pt idx="63">
                  <c:v>16484</c:v>
                </c:pt>
                <c:pt idx="64">
                  <c:v>16686</c:v>
                </c:pt>
                <c:pt idx="65">
                  <c:v>16998</c:v>
                </c:pt>
                <c:pt idx="66">
                  <c:v>16959</c:v>
                </c:pt>
                <c:pt idx="67">
                  <c:v>17340</c:v>
                </c:pt>
                <c:pt idx="68">
                  <c:v>17776</c:v>
                </c:pt>
                <c:pt idx="69">
                  <c:v>17883</c:v>
                </c:pt>
                <c:pt idx="70">
                  <c:v>17886</c:v>
                </c:pt>
                <c:pt idx="71">
                  <c:v>18252</c:v>
                </c:pt>
                <c:pt idx="72">
                  <c:v>18221</c:v>
                </c:pt>
                <c:pt idx="73">
                  <c:v>18567</c:v>
                </c:pt>
                <c:pt idx="74">
                  <c:v>18928</c:v>
                </c:pt>
                <c:pt idx="75">
                  <c:v>18834</c:v>
                </c:pt>
                <c:pt idx="76">
                  <c:v>19050</c:v>
                </c:pt>
                <c:pt idx="77">
                  <c:v>19219</c:v>
                </c:pt>
                <c:pt idx="78">
                  <c:v>19388</c:v>
                </c:pt>
                <c:pt idx="79">
                  <c:v>19465</c:v>
                </c:pt>
                <c:pt idx="80">
                  <c:v>1987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9D57-4078-96E2-30C5D73D89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8075648"/>
        <c:axId val="228110032"/>
      </c:scatterChart>
      <c:valAx>
        <c:axId val="228075648"/>
        <c:scaling>
          <c:orientation val="minMax"/>
          <c:max val="25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ime (Sec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8110032"/>
        <c:crosses val="autoZero"/>
        <c:crossBetween val="midCat"/>
        <c:majorUnit val="500"/>
        <c:minorUnit val="0.8"/>
      </c:valAx>
      <c:valAx>
        <c:axId val="228110032"/>
        <c:scaling>
          <c:orientation val="minMax"/>
          <c:min val="50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 dirty="0" err="1"/>
                  <a:t>Fluorescence</a:t>
                </a:r>
                <a:r>
                  <a:rPr lang="it-IT" dirty="0"/>
                  <a:t> (OD 360nm)</a:t>
                </a:r>
              </a:p>
            </c:rich>
          </c:tx>
          <c:layout>
            <c:manualLayout>
              <c:xMode val="edge"/>
              <c:yMode val="edge"/>
              <c:x val="1.2254817351440499E-2"/>
              <c:y val="0.140102460836862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28075648"/>
        <c:crosses val="autoZero"/>
        <c:crossBetween val="midCat"/>
        <c:majorUnit val="10000"/>
        <c:minorUnit val="1000"/>
      </c:valAx>
    </c:plotArea>
    <c:legend>
      <c:legendPos val="r"/>
      <c:layout>
        <c:manualLayout>
          <c:xMode val="edge"/>
          <c:yMode val="edge"/>
          <c:x val="0.70403542592458102"/>
          <c:y val="2.8498756734355601E-2"/>
          <c:w val="0.29596457407541898"/>
          <c:h val="0.3741583782290370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5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B2A92F-CC39-4839-B8B1-78D03BFB7EDE}" type="datetimeFigureOut">
              <a:rPr lang="it-IT" smtClean="0"/>
              <a:pPr/>
              <a:t>17/02/2017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325886-A4D2-4420-8B96-06FF34E44523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9825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chart" Target="../charts/chart1.xml"/><Relationship Id="rId3" Type="http://schemas.openxmlformats.org/officeDocument/2006/relationships/image" Target="../media/image21.tiff"/><Relationship Id="rId7" Type="http://schemas.openxmlformats.org/officeDocument/2006/relationships/image" Target="../media/image25.png"/><Relationship Id="rId12" Type="http://schemas.openxmlformats.org/officeDocument/2006/relationships/image" Target="../media/image30.pn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0" Type="http://schemas.openxmlformats.org/officeDocument/2006/relationships/image" Target="../media/image28.jpeg"/><Relationship Id="rId4" Type="http://schemas.openxmlformats.org/officeDocument/2006/relationships/image" Target="../media/image22.png"/><Relationship Id="rId9" Type="http://schemas.openxmlformats.org/officeDocument/2006/relationships/image" Target="../media/image27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jpeg"/><Relationship Id="rId13" Type="http://schemas.openxmlformats.org/officeDocument/2006/relationships/image" Target="../media/image42.jpeg"/><Relationship Id="rId18" Type="http://schemas.openxmlformats.org/officeDocument/2006/relationships/image" Target="../media/image47.png"/><Relationship Id="rId26" Type="http://schemas.openxmlformats.org/officeDocument/2006/relationships/image" Target="../media/image53.jpeg"/><Relationship Id="rId3" Type="http://schemas.openxmlformats.org/officeDocument/2006/relationships/image" Target="../media/image32.jpeg"/><Relationship Id="rId21" Type="http://schemas.openxmlformats.org/officeDocument/2006/relationships/image" Target="../media/image50.jpeg"/><Relationship Id="rId7" Type="http://schemas.openxmlformats.org/officeDocument/2006/relationships/image" Target="../media/image36.jpeg"/><Relationship Id="rId12" Type="http://schemas.openxmlformats.org/officeDocument/2006/relationships/image" Target="../media/image41.jpeg"/><Relationship Id="rId17" Type="http://schemas.openxmlformats.org/officeDocument/2006/relationships/image" Target="../media/image46.jpeg"/><Relationship Id="rId25" Type="http://schemas.microsoft.com/office/2007/relationships/hdphoto" Target="../media/hdphoto2.wdp"/><Relationship Id="rId2" Type="http://schemas.openxmlformats.org/officeDocument/2006/relationships/image" Target="../media/image31.jpeg"/><Relationship Id="rId16" Type="http://schemas.openxmlformats.org/officeDocument/2006/relationships/image" Target="../media/image45.jpeg"/><Relationship Id="rId20" Type="http://schemas.openxmlformats.org/officeDocument/2006/relationships/image" Target="../media/image49.jpeg"/><Relationship Id="rId29" Type="http://schemas.microsoft.com/office/2007/relationships/hdphoto" Target="../media/hdphoto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jpeg"/><Relationship Id="rId11" Type="http://schemas.openxmlformats.org/officeDocument/2006/relationships/image" Target="../media/image40.jpeg"/><Relationship Id="rId24" Type="http://schemas.openxmlformats.org/officeDocument/2006/relationships/image" Target="../media/image52.jpeg"/><Relationship Id="rId5" Type="http://schemas.openxmlformats.org/officeDocument/2006/relationships/image" Target="../media/image34.jpeg"/><Relationship Id="rId15" Type="http://schemas.openxmlformats.org/officeDocument/2006/relationships/image" Target="../media/image44.jpeg"/><Relationship Id="rId23" Type="http://schemas.microsoft.com/office/2007/relationships/hdphoto" Target="../media/hdphoto1.wdp"/><Relationship Id="rId28" Type="http://schemas.openxmlformats.org/officeDocument/2006/relationships/image" Target="../media/image54.jpeg"/><Relationship Id="rId10" Type="http://schemas.openxmlformats.org/officeDocument/2006/relationships/image" Target="../media/image39.jpeg"/><Relationship Id="rId19" Type="http://schemas.openxmlformats.org/officeDocument/2006/relationships/image" Target="../media/image48.jpeg"/><Relationship Id="rId4" Type="http://schemas.openxmlformats.org/officeDocument/2006/relationships/image" Target="../media/image33.jpeg"/><Relationship Id="rId9" Type="http://schemas.openxmlformats.org/officeDocument/2006/relationships/image" Target="../media/image38.jpeg"/><Relationship Id="rId14" Type="http://schemas.openxmlformats.org/officeDocument/2006/relationships/image" Target="../media/image43.jpeg"/><Relationship Id="rId22" Type="http://schemas.openxmlformats.org/officeDocument/2006/relationships/image" Target="../media/image51.jpeg"/><Relationship Id="rId27" Type="http://schemas.microsoft.com/office/2007/relationships/hdphoto" Target="../media/hdphoto3.wdp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55.emf"/><Relationship Id="rId4" Type="http://schemas.openxmlformats.org/officeDocument/2006/relationships/package" Target="../embeddings/Microsoft_Word_Document1.docx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7.png"/><Relationship Id="rId5" Type="http://schemas.openxmlformats.org/officeDocument/2006/relationships/image" Target="../media/image56.emf"/><Relationship Id="rId4" Type="http://schemas.openxmlformats.org/officeDocument/2006/relationships/package" Target="../embeddings/Microsoft_Word_Document2.doc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2532406" y="610886"/>
            <a:ext cx="3947806" cy="5091393"/>
            <a:chOff x="2532406" y="610886"/>
            <a:chExt cx="3947806" cy="5091393"/>
          </a:xfrm>
        </p:grpSpPr>
        <p:pic>
          <p:nvPicPr>
            <p:cNvPr id="4" name="Content Placeholder 3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19" t="7299" r="18591" b="10021"/>
            <a:stretch/>
          </p:blipFill>
          <p:spPr>
            <a:xfrm>
              <a:off x="2542123" y="670726"/>
              <a:ext cx="897231" cy="1121538"/>
            </a:xfrm>
            <a:prstGeom prst="rect">
              <a:avLst/>
            </a:prstGeom>
          </p:spPr>
        </p:pic>
        <p:pic>
          <p:nvPicPr>
            <p:cNvPr id="5" name="Content Placeholder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95" t="20925" r="19334" b="29288"/>
            <a:stretch/>
          </p:blipFill>
          <p:spPr>
            <a:xfrm rot="5400000">
              <a:off x="3403441" y="782879"/>
              <a:ext cx="1121538" cy="897231"/>
            </a:xfrm>
            <a:prstGeom prst="rect">
              <a:avLst/>
            </a:prstGeom>
          </p:spPr>
        </p:pic>
        <p:pic>
          <p:nvPicPr>
            <p:cNvPr id="6" name="Picture 2" descr="F:\PEHO\Sabellini_Figures\Figure6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19" t="17620" r="18709" b="19523"/>
            <a:stretch/>
          </p:blipFill>
          <p:spPr bwMode="auto">
            <a:xfrm>
              <a:off x="4489066" y="670726"/>
              <a:ext cx="897231" cy="11215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81" b="16138"/>
            <a:stretch/>
          </p:blipFill>
          <p:spPr bwMode="auto">
            <a:xfrm>
              <a:off x="5462538" y="670726"/>
              <a:ext cx="897231" cy="11215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Content Placeholder 3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764" b="13362"/>
            <a:stretch/>
          </p:blipFill>
          <p:spPr>
            <a:xfrm rot="5400000">
              <a:off x="2429867" y="2086117"/>
              <a:ext cx="1121538" cy="897436"/>
            </a:xfrm>
            <a:prstGeom prst="rect">
              <a:avLst/>
            </a:prstGeom>
          </p:spPr>
        </p:pic>
        <p:pic>
          <p:nvPicPr>
            <p:cNvPr id="10" name="Content Placeholder 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8" t="38462" b="11029"/>
            <a:stretch/>
          </p:blipFill>
          <p:spPr>
            <a:xfrm rot="5400000">
              <a:off x="3244961" y="2244700"/>
              <a:ext cx="1121538" cy="58027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541918" y="3356992"/>
              <a:ext cx="887937" cy="1041950"/>
            </a:xfrm>
            <a:prstGeom prst="rect">
              <a:avLst/>
            </a:prstGeom>
          </p:spPr>
        </p:pic>
        <p:pic>
          <p:nvPicPr>
            <p:cNvPr id="14" name="Picture 2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94" t="19734" r="12401" b="15965"/>
            <a:stretch/>
          </p:blipFill>
          <p:spPr bwMode="auto">
            <a:xfrm>
              <a:off x="2532406" y="4580741"/>
              <a:ext cx="845245" cy="11215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5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37" t="4189" r="11343" b="30087"/>
            <a:stretch>
              <a:fillRect/>
            </a:stretch>
          </p:blipFill>
          <p:spPr bwMode="auto">
            <a:xfrm>
              <a:off x="3515595" y="3356992"/>
              <a:ext cx="887937" cy="10419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Immagine 1"/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69" t="19602" r="21510" b="18655"/>
            <a:stretch/>
          </p:blipFill>
          <p:spPr bwMode="auto">
            <a:xfrm>
              <a:off x="4489067" y="3356992"/>
              <a:ext cx="887937" cy="10419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12"/>
            <a:srcRect l="59330" t="56090" r="11977" b="8048"/>
            <a:stretch/>
          </p:blipFill>
          <p:spPr>
            <a:xfrm flipH="1">
              <a:off x="5453027" y="4580741"/>
              <a:ext cx="845245" cy="1121538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13"/>
            <a:srcRect l="5330" t="642" r="203" b="-642"/>
            <a:stretch/>
          </p:blipFill>
          <p:spPr>
            <a:xfrm>
              <a:off x="5462538" y="3356992"/>
              <a:ext cx="835734" cy="1041948"/>
            </a:xfrm>
            <a:prstGeom prst="rect">
              <a:avLst/>
            </a:prstGeom>
          </p:spPr>
        </p:pic>
        <p:pic>
          <p:nvPicPr>
            <p:cNvPr id="20" name="Immagine 4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39" t="10874" r="25590" b="14019"/>
            <a:stretch/>
          </p:blipFill>
          <p:spPr bwMode="auto">
            <a:xfrm>
              <a:off x="4479555" y="4580741"/>
              <a:ext cx="843936" cy="11215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15"/>
            <a:srcRect l="50683" t="5522" r="4647" b="5551"/>
            <a:stretch/>
          </p:blipFill>
          <p:spPr>
            <a:xfrm>
              <a:off x="3506084" y="4580741"/>
              <a:ext cx="845245" cy="1121538"/>
            </a:xfrm>
            <a:prstGeom prst="rect">
              <a:avLst/>
            </a:prstGeom>
          </p:spPr>
        </p:pic>
        <p:pic>
          <p:nvPicPr>
            <p:cNvPr id="22" name="Picture 2" descr="F:\PEHO\Sabellini_Figures\Figure3.JPG"/>
            <p:cNvPicPr>
              <a:picLocks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370" t="14469" r="11318" b="2672"/>
            <a:stretch/>
          </p:blipFill>
          <p:spPr bwMode="auto">
            <a:xfrm>
              <a:off x="4489066" y="1974064"/>
              <a:ext cx="897231" cy="11215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3" name="Picture 2" descr="F:\PEHO\Sabellini_Figures\Figure8.JPG"/>
            <p:cNvPicPr>
              <a:picLocks noChangeAspect="1"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35" t="29570" r="11935" b="233"/>
            <a:stretch/>
          </p:blipFill>
          <p:spPr bwMode="auto">
            <a:xfrm>
              <a:off x="5462537" y="1974064"/>
              <a:ext cx="897231" cy="112430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3204000" y="610886"/>
              <a:ext cx="32762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                  B                 C                 D</a:t>
              </a:r>
              <a:endParaRPr lang="en-GB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204000" y="1916832"/>
              <a:ext cx="32762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           F                        G                 H</a:t>
              </a:r>
              <a:endParaRPr lang="en-GB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204000" y="3284984"/>
              <a:ext cx="32762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I                  J                  K                L </a:t>
              </a:r>
              <a:endParaRPr lang="en-GB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112888" y="4510186"/>
              <a:ext cx="32468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                 N                 O                 P</a:t>
              </a:r>
              <a:endParaRPr lang="en-GB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CasellaDiTesto 147"/>
          <p:cNvSpPr txBox="1"/>
          <p:nvPr/>
        </p:nvSpPr>
        <p:spPr>
          <a:xfrm>
            <a:off x="431540" y="16816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2794766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CasellaDiTesto 33"/>
          <p:cNvSpPr txBox="1"/>
          <p:nvPr/>
        </p:nvSpPr>
        <p:spPr>
          <a:xfrm>
            <a:off x="215516" y="152636"/>
            <a:ext cx="60690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it-IT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it-IT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521689" y="1484784"/>
            <a:ext cx="6822619" cy="4878628"/>
            <a:chOff x="521689" y="1484784"/>
            <a:chExt cx="6822619" cy="4878628"/>
          </a:xfrm>
        </p:grpSpPr>
        <p:grpSp>
          <p:nvGrpSpPr>
            <p:cNvPr id="2" name="Group 1"/>
            <p:cNvGrpSpPr/>
            <p:nvPr/>
          </p:nvGrpSpPr>
          <p:grpSpPr>
            <a:xfrm>
              <a:off x="521689" y="1484784"/>
              <a:ext cx="6822619" cy="4819330"/>
              <a:chOff x="521689" y="1484784"/>
              <a:chExt cx="6822619" cy="4819330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539552" y="1484784"/>
                <a:ext cx="7741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amily A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30683" y="3169793"/>
                <a:ext cx="7825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amily B</a:t>
                </a: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1624627" y="3398178"/>
                <a:ext cx="5719681" cy="1108689"/>
                <a:chOff x="1403648" y="5049180"/>
                <a:chExt cx="5508612" cy="1108689"/>
              </a:xfrm>
            </p:grpSpPr>
            <p:grpSp>
              <p:nvGrpSpPr>
                <p:cNvPr id="9" name="Group 8"/>
                <p:cNvGrpSpPr/>
                <p:nvPr/>
              </p:nvGrpSpPr>
              <p:grpSpPr>
                <a:xfrm>
                  <a:off x="1403648" y="5049180"/>
                  <a:ext cx="5508612" cy="929131"/>
                  <a:chOff x="1583668" y="5037461"/>
                  <a:chExt cx="5508537" cy="999269"/>
                </a:xfrm>
              </p:grpSpPr>
              <p:pic>
                <p:nvPicPr>
                  <p:cNvPr id="3" name="Picture 2"/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583668" y="5037461"/>
                    <a:ext cx="5508537" cy="772082"/>
                  </a:xfrm>
                  <a:prstGeom prst="rect">
                    <a:avLst/>
                  </a:prstGeom>
                </p:spPr>
              </p:pic>
              <p:sp>
                <p:nvSpPr>
                  <p:cNvPr id="6" name="Up Arrow 5"/>
                  <p:cNvSpPr/>
                  <p:nvPr/>
                </p:nvSpPr>
                <p:spPr>
                  <a:xfrm>
                    <a:off x="1821600" y="5878527"/>
                    <a:ext cx="45719" cy="158203"/>
                  </a:xfrm>
                  <a:prstGeom prst="upArrow">
                    <a:avLst>
                      <a:gd name="adj1" fmla="val 21818"/>
                      <a:gd name="adj2" fmla="val 142231"/>
                    </a:avLst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sp>
              <p:nvSpPr>
                <p:cNvPr id="11" name="TextBox 10"/>
                <p:cNvSpPr txBox="1"/>
                <p:nvPr/>
              </p:nvSpPr>
              <p:spPr>
                <a:xfrm>
                  <a:off x="1416618" y="5942425"/>
                  <a:ext cx="5236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RUNE</a:t>
                  </a:r>
                  <a:endParaRPr lang="en-GB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" name="TextBox 12"/>
              <p:cNvSpPr txBox="1"/>
              <p:nvPr/>
            </p:nvSpPr>
            <p:spPr>
              <a:xfrm>
                <a:off x="521689" y="4988205"/>
                <a:ext cx="7906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amily </a:t>
                </a:r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20284" y="1592796"/>
                <a:ext cx="5508000" cy="1285200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83668" y="5013176"/>
                <a:ext cx="5508000" cy="1290938"/>
              </a:xfrm>
              <a:prstGeom prst="rect">
                <a:avLst/>
              </a:prstGeom>
            </p:spPr>
          </p:pic>
        </p:grpSp>
        <p:sp>
          <p:nvSpPr>
            <p:cNvPr id="4" name="TextBox 3"/>
            <p:cNvSpPr txBox="1"/>
            <p:nvPr/>
          </p:nvSpPr>
          <p:spPr>
            <a:xfrm>
              <a:off x="1946125" y="269757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918800" y="614796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983600" y="429237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342186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1500" y="485295"/>
            <a:ext cx="8712968" cy="6372705"/>
            <a:chOff x="71500" y="485295"/>
            <a:chExt cx="8712968" cy="6372705"/>
          </a:xfrm>
        </p:grpSpPr>
        <p:grpSp>
          <p:nvGrpSpPr>
            <p:cNvPr id="150" name="Gruppo 149"/>
            <p:cNvGrpSpPr/>
            <p:nvPr/>
          </p:nvGrpSpPr>
          <p:grpSpPr>
            <a:xfrm>
              <a:off x="71500" y="487705"/>
              <a:ext cx="3794195" cy="2041195"/>
              <a:chOff x="-76200" y="321005"/>
              <a:chExt cx="3794195" cy="2041195"/>
            </a:xfrm>
          </p:grpSpPr>
          <p:sp>
            <p:nvSpPr>
              <p:cNvPr id="49" name="TextBox 2"/>
              <p:cNvSpPr txBox="1"/>
              <p:nvPr/>
            </p:nvSpPr>
            <p:spPr>
              <a:xfrm>
                <a:off x="160948" y="321005"/>
                <a:ext cx="3029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/>
                    <a:cs typeface="Arial"/>
                  </a:rPr>
                  <a:t>A</a:t>
                </a:r>
              </a:p>
            </p:txBody>
          </p:sp>
          <p:sp>
            <p:nvSpPr>
              <p:cNvPr id="50" name="CasellaDiTesto 32"/>
              <p:cNvSpPr txBox="1">
                <a:spLocks noChangeArrowheads="1"/>
              </p:cNvSpPr>
              <p:nvPr/>
            </p:nvSpPr>
            <p:spPr bwMode="auto">
              <a:xfrm>
                <a:off x="-76200" y="753615"/>
                <a:ext cx="190168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it-IT" sz="1000" b="1" dirty="0">
                    <a:latin typeface="Arial"/>
                    <a:cs typeface="Arial"/>
                  </a:rPr>
                  <a:t> </a:t>
                </a:r>
                <a:r>
                  <a:rPr lang="it-IT" sz="1000" b="1" dirty="0" smtClean="0">
                    <a:latin typeface="Arial"/>
                    <a:cs typeface="Arial"/>
                  </a:rPr>
                  <a:t> </a:t>
                </a:r>
                <a:r>
                  <a:rPr lang="it-IT" sz="1000" b="1" cap="small" dirty="0" smtClean="0">
                    <a:latin typeface="Arial"/>
                    <a:cs typeface="Arial"/>
                  </a:rPr>
                  <a:t>Prune</a:t>
                </a:r>
                <a:r>
                  <a:rPr lang="it-IT" sz="1000" b="1" dirty="0" smtClean="0">
                    <a:latin typeface="Arial"/>
                    <a:cs typeface="Arial"/>
                  </a:rPr>
                  <a:t> </a:t>
                </a:r>
                <a:r>
                  <a:rPr lang="it-IT" sz="1000" b="1" dirty="0">
                    <a:latin typeface="Arial"/>
                    <a:cs typeface="Arial"/>
                  </a:rPr>
                  <a:t>FLAG</a:t>
                </a:r>
              </a:p>
            </p:txBody>
          </p:sp>
          <p:pic>
            <p:nvPicPr>
              <p:cNvPr id="51" name="Picture 3"/>
              <p:cNvPicPr>
                <a:picLocks noChangeArrowheads="1"/>
              </p:cNvPicPr>
              <p:nvPr/>
            </p:nvPicPr>
            <p:blipFill>
              <a:blip r:embed="rId2" cstate="print"/>
              <a:srcRect l="11711" t="35948" r="16591" b="58415"/>
              <a:stretch>
                <a:fillRect/>
              </a:stretch>
            </p:blipFill>
            <p:spPr bwMode="auto">
              <a:xfrm>
                <a:off x="990600" y="787480"/>
                <a:ext cx="2320749" cy="31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52" name="CasellaDiTesto 51"/>
              <p:cNvSpPr txBox="1"/>
              <p:nvPr/>
            </p:nvSpPr>
            <p:spPr>
              <a:xfrm>
                <a:off x="-10731" y="990600"/>
                <a:ext cx="1746900" cy="190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700"/>
                  </a:lnSpc>
                </a:pPr>
                <a:r>
                  <a:rPr lang="it-IT" sz="900" b="1" dirty="0">
                    <a:latin typeface="Arial" pitchFamily="34" charset="0"/>
                    <a:cs typeface="Arial" pitchFamily="34" charset="0"/>
                  </a:rPr>
                  <a:t>Long </a:t>
                </a:r>
                <a:r>
                  <a:rPr lang="it-IT" sz="900" b="1" dirty="0" err="1">
                    <a:latin typeface="Arial" pitchFamily="34" charset="0"/>
                    <a:cs typeface="Arial" pitchFamily="34" charset="0"/>
                  </a:rPr>
                  <a:t>exposure</a:t>
                </a:r>
                <a:endParaRPr lang="it-IT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CasellaDiTesto 33"/>
              <p:cNvSpPr txBox="1">
                <a:spLocks noChangeArrowheads="1"/>
              </p:cNvSpPr>
              <p:nvPr/>
            </p:nvSpPr>
            <p:spPr bwMode="auto">
              <a:xfrm>
                <a:off x="307150" y="1278494"/>
                <a:ext cx="125039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l-GR" sz="1000" b="1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it-IT" sz="1000" b="1" dirty="0"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it-IT" sz="1000" b="1" dirty="0" err="1">
                    <a:latin typeface="Arial" pitchFamily="34" charset="0"/>
                    <a:cs typeface="Arial" pitchFamily="34" charset="0"/>
                  </a:rPr>
                  <a:t>Tubulin</a:t>
                </a:r>
                <a:endParaRPr lang="it-IT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54" name="Picture 3" descr="C:\Users\Marianeve\Desktop\tubulina flora.TIF"/>
              <p:cNvPicPr>
                <a:picLocks noChangeArrowheads="1"/>
              </p:cNvPicPr>
              <p:nvPr/>
            </p:nvPicPr>
            <p:blipFill>
              <a:blip r:embed="rId3" cstate="print"/>
              <a:srcRect l="14601" t="33104" r="16046" b="33793"/>
              <a:stretch>
                <a:fillRect/>
              </a:stretch>
            </p:blipFill>
            <p:spPr bwMode="auto">
              <a:xfrm>
                <a:off x="990600" y="1212000"/>
                <a:ext cx="2320749" cy="312000"/>
              </a:xfrm>
              <a:prstGeom prst="rect">
                <a:avLst/>
              </a:prstGeom>
              <a:noFill/>
            </p:spPr>
          </p:pic>
          <p:grpSp>
            <p:nvGrpSpPr>
              <p:cNvPr id="55" name="Gruppo 54"/>
              <p:cNvGrpSpPr/>
              <p:nvPr/>
            </p:nvGrpSpPr>
            <p:grpSpPr>
              <a:xfrm>
                <a:off x="639228" y="1476427"/>
                <a:ext cx="1890637" cy="416723"/>
                <a:chOff x="3520536" y="1403626"/>
                <a:chExt cx="1613041" cy="288500"/>
              </a:xfrm>
            </p:grpSpPr>
            <p:sp>
              <p:nvSpPr>
                <p:cNvPr id="56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520536" y="1487332"/>
                  <a:ext cx="574682" cy="174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cap="small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</a:t>
                  </a:r>
                  <a:r>
                    <a:rPr lang="it-IT" sz="8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 WT</a:t>
                  </a:r>
                  <a:endParaRPr lang="it-IT" sz="800" b="1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57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644024" y="1528945"/>
                  <a:ext cx="663579" cy="1631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cap="small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D30N</a:t>
                  </a:r>
                </a:p>
              </p:txBody>
            </p:sp>
            <p:sp>
              <p:nvSpPr>
                <p:cNvPr id="58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829974" y="1525264"/>
                  <a:ext cx="731960" cy="1631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cap="small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R297W</a:t>
                  </a:r>
                </a:p>
              </p:txBody>
            </p:sp>
            <p:sp>
              <p:nvSpPr>
                <p:cNvPr id="59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998224" y="1403626"/>
                  <a:ext cx="1135353" cy="1704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Empty</a:t>
                  </a:r>
                  <a:r>
                    <a:rPr lang="it-IT" sz="8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 </a:t>
                  </a:r>
                  <a:r>
                    <a:rPr lang="it-IT" sz="8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vector</a:t>
                  </a:r>
                  <a:endParaRPr lang="it-IT" sz="800" b="1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60" name="Gruppo 59"/>
              <p:cNvGrpSpPr/>
              <p:nvPr/>
            </p:nvGrpSpPr>
            <p:grpSpPr>
              <a:xfrm>
                <a:off x="1827359" y="1476425"/>
                <a:ext cx="1890636" cy="407717"/>
                <a:chOff x="3543618" y="1403629"/>
                <a:chExt cx="1613040" cy="282266"/>
              </a:xfrm>
            </p:grpSpPr>
            <p:sp>
              <p:nvSpPr>
                <p:cNvPr id="61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543618" y="1480094"/>
                  <a:ext cx="574682" cy="1631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cap="small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WT</a:t>
                  </a:r>
                </a:p>
              </p:txBody>
            </p:sp>
            <p:sp>
              <p:nvSpPr>
                <p:cNvPr id="62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686021" y="1519033"/>
                  <a:ext cx="663578" cy="1631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cap="small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D30N</a:t>
                  </a:r>
                </a:p>
              </p:txBody>
            </p:sp>
            <p:sp>
              <p:nvSpPr>
                <p:cNvPr id="63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892454" y="1522714"/>
                  <a:ext cx="731960" cy="1631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cap="small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R297W</a:t>
                  </a:r>
                </a:p>
              </p:txBody>
            </p:sp>
            <p:sp>
              <p:nvSpPr>
                <p:cNvPr id="64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4021305" y="1403629"/>
                  <a:ext cx="1135353" cy="1704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Empty</a:t>
                  </a:r>
                  <a:r>
                    <a:rPr lang="it-IT" sz="8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 </a:t>
                  </a:r>
                  <a:r>
                    <a:rPr lang="it-IT" sz="8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vector</a:t>
                  </a:r>
                  <a:endParaRPr lang="it-IT" sz="800" b="1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65" name="Rettangolo 11"/>
              <p:cNvSpPr>
                <a:spLocks noChangeArrowheads="1"/>
              </p:cNvSpPr>
              <p:nvPr/>
            </p:nvSpPr>
            <p:spPr bwMode="auto">
              <a:xfrm>
                <a:off x="2215742" y="423415"/>
                <a:ext cx="13619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/>
                    <a:cs typeface="Arial"/>
                  </a:rPr>
                  <a:t>IP </a:t>
                </a:r>
                <a:r>
                  <a:rPr lang="el-GR" sz="1000" dirty="0">
                    <a:latin typeface="Arial"/>
                    <a:cs typeface="Arial"/>
                  </a:rPr>
                  <a:t>β</a:t>
                </a:r>
                <a:r>
                  <a:rPr lang="it-IT" sz="1000" dirty="0">
                    <a:latin typeface="Arial"/>
                    <a:cs typeface="Arial"/>
                  </a:rPr>
                  <a:t>-</a:t>
                </a:r>
                <a:r>
                  <a:rPr lang="it-IT" sz="1000" dirty="0" err="1">
                    <a:latin typeface="Arial"/>
                    <a:cs typeface="Arial"/>
                  </a:rPr>
                  <a:t>Tubulin</a:t>
                </a:r>
                <a:r>
                  <a:rPr lang="it-IT" sz="1000" dirty="0">
                    <a:latin typeface="Arial"/>
                    <a:cs typeface="Arial"/>
                  </a:rPr>
                  <a:t> </a:t>
                </a:r>
              </a:p>
            </p:txBody>
          </p:sp>
          <p:sp>
            <p:nvSpPr>
              <p:cNvPr id="66" name="Rettangolo 13"/>
              <p:cNvSpPr>
                <a:spLocks noChangeArrowheads="1"/>
              </p:cNvSpPr>
              <p:nvPr/>
            </p:nvSpPr>
            <p:spPr bwMode="auto">
              <a:xfrm>
                <a:off x="1184624" y="423415"/>
                <a:ext cx="88983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/>
                    <a:cs typeface="Arial"/>
                  </a:rPr>
                  <a:t>INPUT</a:t>
                </a:r>
              </a:p>
            </p:txBody>
          </p:sp>
          <p:cxnSp>
            <p:nvCxnSpPr>
              <p:cNvPr id="67" name="Connettore 1 66"/>
              <p:cNvCxnSpPr/>
              <p:nvPr/>
            </p:nvCxnSpPr>
            <p:spPr bwMode="auto">
              <a:xfrm>
                <a:off x="1110975" y="750068"/>
                <a:ext cx="1043776" cy="3545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Connettore 1 67"/>
              <p:cNvCxnSpPr/>
              <p:nvPr/>
            </p:nvCxnSpPr>
            <p:spPr bwMode="auto">
              <a:xfrm>
                <a:off x="2215742" y="753613"/>
                <a:ext cx="1191078" cy="0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Rettangolo 25"/>
              <p:cNvSpPr>
                <a:spLocks noChangeArrowheads="1"/>
              </p:cNvSpPr>
              <p:nvPr/>
            </p:nvSpPr>
            <p:spPr bwMode="auto">
              <a:xfrm>
                <a:off x="801729" y="2115979"/>
                <a:ext cx="247395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sz="1000" b="1" dirty="0">
                    <a:latin typeface="Arial"/>
                    <a:cs typeface="Arial"/>
                  </a:rPr>
                  <a:t>SHSY5Y + Doxycycline</a:t>
                </a:r>
              </a:p>
            </p:txBody>
          </p:sp>
          <p:cxnSp>
            <p:nvCxnSpPr>
              <p:cNvPr id="70" name="Connettore 1 69"/>
              <p:cNvCxnSpPr/>
              <p:nvPr/>
            </p:nvCxnSpPr>
            <p:spPr bwMode="auto">
              <a:xfrm>
                <a:off x="1066800" y="2133600"/>
                <a:ext cx="2232841" cy="0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Gruppo 84"/>
            <p:cNvGrpSpPr/>
            <p:nvPr/>
          </p:nvGrpSpPr>
          <p:grpSpPr>
            <a:xfrm>
              <a:off x="6727586" y="1553185"/>
              <a:ext cx="1943642" cy="425658"/>
              <a:chOff x="3567090" y="1460730"/>
              <a:chExt cx="1549113" cy="294685"/>
            </a:xfrm>
          </p:grpSpPr>
          <p:sp>
            <p:nvSpPr>
              <p:cNvPr id="86" name="Rettangolo 21"/>
              <p:cNvSpPr>
                <a:spLocks noChangeArrowheads="1"/>
              </p:cNvSpPr>
              <p:nvPr/>
            </p:nvSpPr>
            <p:spPr bwMode="auto">
              <a:xfrm rot="19106818">
                <a:off x="3567090" y="1562628"/>
                <a:ext cx="536855" cy="1631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pPr>
                  <a:lnSpc>
                    <a:spcPct val="130000"/>
                  </a:lnSpc>
                </a:pPr>
                <a:r>
                  <a:rPr lang="it-IT" sz="800" b="1" cap="small" dirty="0">
                    <a:solidFill>
                      <a:srgbClr val="000000"/>
                    </a:solidFill>
                    <a:latin typeface="Arial"/>
                    <a:cs typeface="Arial"/>
                  </a:rPr>
                  <a:t>Prune WT</a:t>
                </a:r>
              </a:p>
            </p:txBody>
          </p:sp>
          <p:sp>
            <p:nvSpPr>
              <p:cNvPr id="87" name="Rettangolo 21"/>
              <p:cNvSpPr>
                <a:spLocks noChangeArrowheads="1"/>
              </p:cNvSpPr>
              <p:nvPr/>
            </p:nvSpPr>
            <p:spPr bwMode="auto">
              <a:xfrm rot="19106818">
                <a:off x="3671423" y="1588554"/>
                <a:ext cx="619900" cy="1631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pPr>
                  <a:lnSpc>
                    <a:spcPct val="130000"/>
                  </a:lnSpc>
                </a:pPr>
                <a:r>
                  <a:rPr lang="it-IT" sz="800" b="1" cap="small" dirty="0">
                    <a:solidFill>
                      <a:srgbClr val="000000"/>
                    </a:solidFill>
                    <a:latin typeface="Arial"/>
                    <a:cs typeface="Arial"/>
                  </a:rPr>
                  <a:t>Prune D30N</a:t>
                </a:r>
              </a:p>
            </p:txBody>
          </p:sp>
          <p:sp>
            <p:nvSpPr>
              <p:cNvPr id="88" name="Rettangolo 21"/>
              <p:cNvSpPr>
                <a:spLocks noChangeArrowheads="1"/>
              </p:cNvSpPr>
              <p:nvPr/>
            </p:nvSpPr>
            <p:spPr bwMode="auto">
              <a:xfrm rot="19106818">
                <a:off x="3864268" y="1592235"/>
                <a:ext cx="683781" cy="1631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pPr>
                  <a:lnSpc>
                    <a:spcPct val="130000"/>
                  </a:lnSpc>
                </a:pPr>
                <a:r>
                  <a:rPr lang="it-IT" sz="800" b="1" cap="small" dirty="0">
                    <a:solidFill>
                      <a:srgbClr val="000000"/>
                    </a:solidFill>
                    <a:latin typeface="Arial"/>
                    <a:cs typeface="Arial"/>
                  </a:rPr>
                  <a:t>Prune R297W</a:t>
                </a:r>
              </a:p>
            </p:txBody>
          </p:sp>
          <p:sp>
            <p:nvSpPr>
              <p:cNvPr id="89" name="Rettangolo 21"/>
              <p:cNvSpPr>
                <a:spLocks noChangeArrowheads="1"/>
              </p:cNvSpPr>
              <p:nvPr/>
            </p:nvSpPr>
            <p:spPr bwMode="auto">
              <a:xfrm rot="19106818">
                <a:off x="3980850" y="1460730"/>
                <a:ext cx="1135353" cy="1704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pPr>
                  <a:lnSpc>
                    <a:spcPct val="130000"/>
                  </a:lnSpc>
                </a:pPr>
                <a:r>
                  <a:rPr lang="it-IT" sz="800" b="1" dirty="0" err="1">
                    <a:solidFill>
                      <a:srgbClr val="000000"/>
                    </a:solidFill>
                    <a:latin typeface="Arial"/>
                    <a:cs typeface="Arial"/>
                  </a:rPr>
                  <a:t>Empty</a:t>
                </a:r>
                <a:r>
                  <a:rPr lang="it-IT" sz="8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 </a:t>
                </a:r>
                <a:r>
                  <a:rPr lang="it-IT" sz="800" b="1" dirty="0" err="1">
                    <a:solidFill>
                      <a:srgbClr val="000000"/>
                    </a:solidFill>
                    <a:latin typeface="Arial"/>
                    <a:cs typeface="Arial"/>
                  </a:rPr>
                  <a:t>vector</a:t>
                </a:r>
                <a:endParaRPr lang="it-IT" sz="800" b="1" baseline="30000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149" name="Gruppo 148"/>
            <p:cNvGrpSpPr/>
            <p:nvPr/>
          </p:nvGrpSpPr>
          <p:grpSpPr>
            <a:xfrm>
              <a:off x="4716016" y="485295"/>
              <a:ext cx="3844375" cy="2043605"/>
              <a:chOff x="3989784" y="341279"/>
              <a:chExt cx="3844375" cy="2043605"/>
            </a:xfrm>
          </p:grpSpPr>
          <p:sp>
            <p:nvSpPr>
              <p:cNvPr id="48" name="TextBox 2"/>
              <p:cNvSpPr txBox="1"/>
              <p:nvPr/>
            </p:nvSpPr>
            <p:spPr>
              <a:xfrm>
                <a:off x="3989784" y="341279"/>
                <a:ext cx="29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/>
                    <a:cs typeface="Arial"/>
                  </a:rPr>
                  <a:t>B</a:t>
                </a:r>
              </a:p>
            </p:txBody>
          </p:sp>
          <p:pic>
            <p:nvPicPr>
              <p:cNvPr id="71" name="Immagine 16" descr="Ip tub riv tub.tif"/>
              <p:cNvPicPr preferRelativeResize="0">
                <a:picLocks/>
              </p:cNvPicPr>
              <p:nvPr/>
            </p:nvPicPr>
            <p:blipFill>
              <a:blip r:embed="rId4" cstate="print">
                <a:duotone>
                  <a:prstClr val="black"/>
                  <a:srgbClr val="D9C3A5">
                    <a:tint val="50000"/>
                    <a:satMod val="180000"/>
                  </a:srgbClr>
                </a:duotone>
              </a:blip>
              <a:srcRect l="18074" t="15049" r="68408" b="82455"/>
              <a:stretch>
                <a:fillRect/>
              </a:stretch>
            </p:blipFill>
            <p:spPr bwMode="auto">
              <a:xfrm>
                <a:off x="6275784" y="1148063"/>
                <a:ext cx="1219550" cy="31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2" name="Picture 38"/>
              <p:cNvPicPr>
                <a:picLocks noChangeArrowheads="1"/>
              </p:cNvPicPr>
              <p:nvPr/>
            </p:nvPicPr>
            <p:blipFill>
              <a:blip r:embed="rId5" cstate="print">
                <a:duotone>
                  <a:prstClr val="black"/>
                  <a:srgbClr val="D9C3A5">
                    <a:tint val="50000"/>
                    <a:satMod val="180000"/>
                  </a:srgbClr>
                </a:duotone>
              </a:blip>
              <a:srcRect t="8426" r="50993"/>
              <a:stretch>
                <a:fillRect/>
              </a:stretch>
            </p:blipFill>
            <p:spPr bwMode="auto">
              <a:xfrm>
                <a:off x="4980384" y="767063"/>
                <a:ext cx="1219550" cy="31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3" name="Picture 39"/>
              <p:cNvPicPr>
                <a:picLocks noChangeArrowheads="1"/>
              </p:cNvPicPr>
              <p:nvPr/>
            </p:nvPicPr>
            <p:blipFill>
              <a:blip r:embed="rId6" cstate="print">
                <a:duotone>
                  <a:prstClr val="black"/>
                  <a:srgbClr val="D9C3A5">
                    <a:tint val="50000"/>
                    <a:satMod val="180000"/>
                  </a:srgbClr>
                </a:duotone>
              </a:blip>
              <a:srcRect l="49007" t="-6535"/>
              <a:stretch>
                <a:fillRect/>
              </a:stretch>
            </p:blipFill>
            <p:spPr bwMode="auto">
              <a:xfrm>
                <a:off x="6275784" y="767063"/>
                <a:ext cx="1219550" cy="31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4" name="Immagine 16" descr="Ip tub riv tub.tif"/>
              <p:cNvPicPr preferRelativeResize="0">
                <a:picLocks/>
              </p:cNvPicPr>
              <p:nvPr/>
            </p:nvPicPr>
            <p:blipFill>
              <a:blip r:embed="rId4" cstate="print">
                <a:duotone>
                  <a:prstClr val="black"/>
                  <a:srgbClr val="D9C3A5">
                    <a:tint val="50000"/>
                    <a:satMod val="180000"/>
                  </a:srgbClr>
                </a:duotone>
              </a:blip>
              <a:srcRect l="7021" t="14854" r="81959" b="82455"/>
              <a:stretch>
                <a:fillRect/>
              </a:stretch>
            </p:blipFill>
            <p:spPr bwMode="auto">
              <a:xfrm>
                <a:off x="4980384" y="1148063"/>
                <a:ext cx="1219550" cy="31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5" name="CasellaDiTesto 33"/>
              <p:cNvSpPr txBox="1">
                <a:spLocks noChangeArrowheads="1"/>
              </p:cNvSpPr>
              <p:nvPr/>
            </p:nvSpPr>
            <p:spPr bwMode="auto">
              <a:xfrm>
                <a:off x="4294584" y="1224263"/>
                <a:ext cx="1242887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it-IT" sz="1000" b="1" dirty="0">
                    <a:latin typeface="Arial"/>
                    <a:cs typeface="Arial"/>
                  </a:rPr>
                  <a:t>α-</a:t>
                </a:r>
                <a:r>
                  <a:rPr lang="it-IT" sz="1000" b="1" dirty="0" err="1">
                    <a:latin typeface="Arial"/>
                    <a:cs typeface="Arial"/>
                  </a:rPr>
                  <a:t>Tubulin</a:t>
                </a:r>
                <a:endParaRPr lang="it-IT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76" name="CasellaDiTesto 32"/>
              <p:cNvSpPr txBox="1">
                <a:spLocks noChangeArrowheads="1"/>
              </p:cNvSpPr>
              <p:nvPr/>
            </p:nvSpPr>
            <p:spPr bwMode="auto">
              <a:xfrm>
                <a:off x="3989784" y="767063"/>
                <a:ext cx="2035675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it-IT" sz="1000" b="1" cap="small" dirty="0" smtClean="0">
                    <a:latin typeface="Arial"/>
                    <a:cs typeface="Arial"/>
                  </a:rPr>
                  <a:t>Prune </a:t>
                </a:r>
                <a:r>
                  <a:rPr lang="it-IT" sz="1000" b="1" cap="small" dirty="0">
                    <a:latin typeface="Arial"/>
                    <a:cs typeface="Arial"/>
                  </a:rPr>
                  <a:t>FLAG</a:t>
                </a:r>
              </a:p>
            </p:txBody>
          </p:sp>
          <p:sp>
            <p:nvSpPr>
              <p:cNvPr id="77" name="CasellaDiTesto 76"/>
              <p:cNvSpPr txBox="1"/>
              <p:nvPr/>
            </p:nvSpPr>
            <p:spPr>
              <a:xfrm>
                <a:off x="3989784" y="995663"/>
                <a:ext cx="1869987" cy="190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700"/>
                  </a:lnSpc>
                </a:pPr>
                <a:r>
                  <a:rPr lang="it-IT" sz="900" b="1" dirty="0">
                    <a:latin typeface="Arial" pitchFamily="34" charset="0"/>
                    <a:cs typeface="Arial" pitchFamily="34" charset="0"/>
                  </a:rPr>
                  <a:t>Long </a:t>
                </a:r>
                <a:r>
                  <a:rPr lang="it-IT" sz="900" b="1" dirty="0" err="1">
                    <a:latin typeface="Arial" pitchFamily="34" charset="0"/>
                    <a:cs typeface="Arial" pitchFamily="34" charset="0"/>
                  </a:rPr>
                  <a:t>exposure</a:t>
                </a:r>
                <a:endParaRPr lang="it-IT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ttangolo 25"/>
              <p:cNvSpPr>
                <a:spLocks noChangeArrowheads="1"/>
              </p:cNvSpPr>
              <p:nvPr/>
            </p:nvSpPr>
            <p:spPr bwMode="auto">
              <a:xfrm>
                <a:off x="5056584" y="2138663"/>
                <a:ext cx="264827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sz="1000" b="1" dirty="0">
                    <a:latin typeface="Arial"/>
                    <a:cs typeface="Arial"/>
                  </a:rPr>
                  <a:t>SHSY5Y + Doxycycline</a:t>
                </a:r>
              </a:p>
            </p:txBody>
          </p:sp>
          <p:cxnSp>
            <p:nvCxnSpPr>
              <p:cNvPr id="79" name="Connettore 1 78"/>
              <p:cNvCxnSpPr/>
              <p:nvPr/>
            </p:nvCxnSpPr>
            <p:spPr bwMode="auto">
              <a:xfrm>
                <a:off x="4980384" y="2138663"/>
                <a:ext cx="2485774" cy="0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0" name="Gruppo 79"/>
              <p:cNvGrpSpPr/>
              <p:nvPr/>
            </p:nvGrpSpPr>
            <p:grpSpPr>
              <a:xfrm>
                <a:off x="4597198" y="1382809"/>
                <a:ext cx="2092692" cy="460344"/>
                <a:chOff x="3567243" y="1440815"/>
                <a:chExt cx="1667907" cy="318699"/>
              </a:xfrm>
            </p:grpSpPr>
            <p:sp>
              <p:nvSpPr>
                <p:cNvPr id="81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567243" y="1555186"/>
                  <a:ext cx="536855" cy="174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cap="small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WT</a:t>
                  </a:r>
                </a:p>
              </p:txBody>
            </p:sp>
            <p:sp>
              <p:nvSpPr>
                <p:cNvPr id="82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711298" y="1581113"/>
                  <a:ext cx="619900" cy="174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cap="small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D30N</a:t>
                  </a:r>
                </a:p>
              </p:txBody>
            </p:sp>
            <p:sp>
              <p:nvSpPr>
                <p:cNvPr id="83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913704" y="1584792"/>
                  <a:ext cx="683781" cy="174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cap="small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R297W</a:t>
                  </a:r>
                </a:p>
              </p:txBody>
            </p:sp>
            <p:sp>
              <p:nvSpPr>
                <p:cNvPr id="84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4099797" y="1440815"/>
                  <a:ext cx="1135353" cy="1704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Empty</a:t>
                  </a:r>
                  <a:r>
                    <a:rPr lang="it-IT" sz="8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 </a:t>
                  </a:r>
                  <a:r>
                    <a:rPr lang="it-IT" sz="8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vector</a:t>
                  </a:r>
                  <a:endParaRPr lang="it-IT" sz="800" b="1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90" name="Rettangolo 11"/>
              <p:cNvSpPr>
                <a:spLocks noChangeArrowheads="1"/>
              </p:cNvSpPr>
              <p:nvPr/>
            </p:nvSpPr>
            <p:spPr bwMode="auto">
              <a:xfrm>
                <a:off x="6375671" y="386063"/>
                <a:ext cx="145848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/>
                    <a:cs typeface="Arial"/>
                  </a:rPr>
                  <a:t>IP </a:t>
                </a:r>
                <a:r>
                  <a:rPr lang="el-GR" sz="1000" dirty="0">
                    <a:latin typeface="Arial"/>
                    <a:cs typeface="Arial"/>
                  </a:rPr>
                  <a:t>α</a:t>
                </a:r>
                <a:r>
                  <a:rPr lang="it-IT" sz="1000" dirty="0">
                    <a:latin typeface="Arial"/>
                    <a:cs typeface="Arial"/>
                  </a:rPr>
                  <a:t>-</a:t>
                </a:r>
                <a:r>
                  <a:rPr lang="it-IT" sz="1000" dirty="0" err="1">
                    <a:latin typeface="Arial"/>
                    <a:cs typeface="Arial"/>
                  </a:rPr>
                  <a:t>Tubulin</a:t>
                </a:r>
                <a:r>
                  <a:rPr lang="it-IT" sz="1000" dirty="0">
                    <a:latin typeface="Arial"/>
                    <a:cs typeface="Arial"/>
                  </a:rPr>
                  <a:t> </a:t>
                </a:r>
              </a:p>
            </p:txBody>
          </p:sp>
          <p:sp>
            <p:nvSpPr>
              <p:cNvPr id="91" name="Rettangolo 13"/>
              <p:cNvSpPr>
                <a:spLocks noChangeArrowheads="1"/>
              </p:cNvSpPr>
              <p:nvPr/>
            </p:nvSpPr>
            <p:spPr bwMode="auto">
              <a:xfrm>
                <a:off x="5271901" y="386063"/>
                <a:ext cx="95253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/>
                    <a:cs typeface="Arial"/>
                  </a:rPr>
                  <a:t>INPUT</a:t>
                </a:r>
              </a:p>
            </p:txBody>
          </p:sp>
          <p:cxnSp>
            <p:nvCxnSpPr>
              <p:cNvPr id="92" name="Connettore 1 91"/>
              <p:cNvCxnSpPr/>
              <p:nvPr/>
            </p:nvCxnSpPr>
            <p:spPr bwMode="auto">
              <a:xfrm>
                <a:off x="4980384" y="712716"/>
                <a:ext cx="1117320" cy="3545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ttore 1 92"/>
              <p:cNvCxnSpPr/>
              <p:nvPr/>
            </p:nvCxnSpPr>
            <p:spPr bwMode="auto">
              <a:xfrm>
                <a:off x="6275784" y="716261"/>
                <a:ext cx="1275002" cy="0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9" name="Gruppo 128"/>
            <p:cNvGrpSpPr/>
            <p:nvPr/>
          </p:nvGrpSpPr>
          <p:grpSpPr>
            <a:xfrm>
              <a:off x="308648" y="2888940"/>
              <a:ext cx="2405846" cy="1402494"/>
              <a:chOff x="-127084" y="3162611"/>
              <a:chExt cx="2405846" cy="1402494"/>
            </a:xfrm>
          </p:grpSpPr>
          <p:grpSp>
            <p:nvGrpSpPr>
              <p:cNvPr id="94" name="Gruppo 93"/>
              <p:cNvGrpSpPr/>
              <p:nvPr/>
            </p:nvGrpSpPr>
            <p:grpSpPr>
              <a:xfrm>
                <a:off x="-76200" y="3505200"/>
                <a:ext cx="2006071" cy="663927"/>
                <a:chOff x="-377064" y="1028204"/>
                <a:chExt cx="2674762" cy="459642"/>
              </a:xfrm>
            </p:grpSpPr>
            <p:grpSp>
              <p:nvGrpSpPr>
                <p:cNvPr id="95" name="Gruppo 94"/>
                <p:cNvGrpSpPr/>
                <p:nvPr/>
              </p:nvGrpSpPr>
              <p:grpSpPr>
                <a:xfrm>
                  <a:off x="943737" y="1028204"/>
                  <a:ext cx="1353961" cy="459642"/>
                  <a:chOff x="4989578" y="2042605"/>
                  <a:chExt cx="1353962" cy="459642"/>
                </a:xfrm>
              </p:grpSpPr>
              <p:pic>
                <p:nvPicPr>
                  <p:cNvPr id="98" name="Picture 5"/>
                  <p:cNvPicPr>
                    <a:picLocks noChangeAspect="1" noChangeArrowheads="1"/>
                  </p:cNvPicPr>
                  <p:nvPr/>
                </p:nvPicPr>
                <p:blipFill>
                  <a:blip r:embed="rId7" cstate="print"/>
                  <a:srcRect l="40081" t="39063" r="22584" b="52148"/>
                  <a:stretch>
                    <a:fillRect/>
                  </a:stretch>
                </p:blipFill>
                <p:spPr bwMode="auto">
                  <a:xfrm>
                    <a:off x="4989578" y="2042605"/>
                    <a:ext cx="1353962" cy="2098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99" name="Picture 7"/>
                  <p:cNvPicPr>
                    <a:picLocks noChangeAspect="1" noChangeArrowheads="1"/>
                  </p:cNvPicPr>
                  <p:nvPr/>
                </p:nvPicPr>
                <p:blipFill>
                  <a:blip r:embed="rId8" cstate="print"/>
                  <a:srcRect l="36786" t="39063" r="20937" b="50195"/>
                  <a:stretch>
                    <a:fillRect/>
                  </a:stretch>
                </p:blipFill>
                <p:spPr bwMode="auto">
                  <a:xfrm>
                    <a:off x="4989578" y="2292415"/>
                    <a:ext cx="1353962" cy="2098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</p:grpSp>
            <p:sp>
              <p:nvSpPr>
                <p:cNvPr id="96" name="CasellaDiTesto 47"/>
                <p:cNvSpPr txBox="1"/>
                <p:nvPr/>
              </p:nvSpPr>
              <p:spPr>
                <a:xfrm>
                  <a:off x="60117" y="1274426"/>
                  <a:ext cx="834991" cy="1704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000" b="1" dirty="0">
                      <a:latin typeface="Arial"/>
                      <a:cs typeface="Arial"/>
                    </a:rPr>
                    <a:t>β</a:t>
                  </a:r>
                  <a:r>
                    <a:rPr lang="it-IT" sz="1000" b="1" dirty="0">
                      <a:latin typeface="Arial"/>
                      <a:cs typeface="Arial"/>
                    </a:rPr>
                    <a:t>-Actin</a:t>
                  </a:r>
                </a:p>
              </p:txBody>
            </p:sp>
            <p:sp>
              <p:nvSpPr>
                <p:cNvPr id="97" name="CasellaDiTesto 50"/>
                <p:cNvSpPr txBox="1"/>
                <p:nvPr/>
              </p:nvSpPr>
              <p:spPr>
                <a:xfrm>
                  <a:off x="-377064" y="1028205"/>
                  <a:ext cx="1259319" cy="1704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cap="small" dirty="0">
                      <a:latin typeface="Arial"/>
                      <a:cs typeface="Arial"/>
                    </a:rPr>
                    <a:t>Prune</a:t>
                  </a:r>
                  <a:r>
                    <a:rPr lang="it-IT" sz="1000" b="1" dirty="0">
                      <a:latin typeface="Arial"/>
                      <a:cs typeface="Arial"/>
                    </a:rPr>
                    <a:t> FLAG</a:t>
                  </a:r>
                </a:p>
              </p:txBody>
            </p:sp>
          </p:grpSp>
          <p:sp>
            <p:nvSpPr>
              <p:cNvPr id="100" name="CasellaDiTesto 31"/>
              <p:cNvSpPr txBox="1"/>
              <p:nvPr/>
            </p:nvSpPr>
            <p:spPr>
              <a:xfrm>
                <a:off x="-127084" y="3162611"/>
                <a:ext cx="990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>
                    <a:latin typeface="Arial" pitchFamily="34" charset="0"/>
                    <a:cs typeface="Arial" pitchFamily="34" charset="0"/>
                  </a:rPr>
                  <a:t>C</a:t>
                </a:r>
              </a:p>
            </p:txBody>
          </p:sp>
          <p:sp>
            <p:nvSpPr>
              <p:cNvPr id="103" name="TextBox 1"/>
              <p:cNvSpPr txBox="1"/>
              <p:nvPr/>
            </p:nvSpPr>
            <p:spPr>
              <a:xfrm>
                <a:off x="762000" y="3230749"/>
                <a:ext cx="15167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SHSY5Y </a:t>
                </a:r>
                <a:r>
                  <a:rPr lang="en-US" sz="1000" dirty="0">
                    <a:latin typeface="Arial"/>
                    <a:cs typeface="Arial"/>
                  </a:rPr>
                  <a:t>+ Doxycycline</a:t>
                </a:r>
              </a:p>
            </p:txBody>
          </p:sp>
          <p:grpSp>
            <p:nvGrpSpPr>
              <p:cNvPr id="109" name="Gruppo 108"/>
              <p:cNvGrpSpPr/>
              <p:nvPr/>
            </p:nvGrpSpPr>
            <p:grpSpPr>
              <a:xfrm>
                <a:off x="380999" y="4253761"/>
                <a:ext cx="1625885" cy="311344"/>
                <a:chOff x="3123637" y="1499842"/>
                <a:chExt cx="1539490" cy="113247"/>
              </a:xfrm>
            </p:grpSpPr>
            <p:sp>
              <p:nvSpPr>
                <p:cNvPr id="110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495932" y="1518828"/>
                  <a:ext cx="692431" cy="917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</a:t>
                  </a:r>
                  <a:r>
                    <a:rPr lang="it-IT" sz="8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WT</a:t>
                  </a:r>
                  <a:endParaRPr lang="it-IT" sz="800" b="1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111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635228" y="1519354"/>
                  <a:ext cx="791089" cy="917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D30N</a:t>
                  </a:r>
                  <a:endParaRPr lang="it-IT" sz="800" b="1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112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796146" y="1521290"/>
                  <a:ext cx="866981" cy="917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PRUNE </a:t>
                  </a:r>
                  <a:r>
                    <a:rPr lang="it-IT" sz="8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R297W</a:t>
                  </a:r>
                  <a:endParaRPr lang="it-IT" sz="800" b="1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113" name="Rettangolo 21"/>
                <p:cNvSpPr>
                  <a:spLocks noChangeArrowheads="1"/>
                </p:cNvSpPr>
                <p:nvPr/>
              </p:nvSpPr>
              <p:spPr bwMode="auto">
                <a:xfrm rot="19106818">
                  <a:off x="3123637" y="1499842"/>
                  <a:ext cx="1135354" cy="8955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30000"/>
                    </a:lnSpc>
                  </a:pPr>
                  <a:r>
                    <a:rPr lang="it-IT" sz="8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Empty</a:t>
                  </a:r>
                  <a:r>
                    <a:rPr lang="it-IT" sz="8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 </a:t>
                  </a:r>
                  <a:r>
                    <a:rPr lang="it-IT" sz="8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vector</a:t>
                  </a:r>
                  <a:endParaRPr lang="it-IT" sz="800" b="1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131" name="Gruppo 130"/>
            <p:cNvGrpSpPr/>
            <p:nvPr/>
          </p:nvGrpSpPr>
          <p:grpSpPr>
            <a:xfrm>
              <a:off x="3563888" y="2796985"/>
              <a:ext cx="1605507" cy="2087970"/>
              <a:chOff x="5472100" y="2600908"/>
              <a:chExt cx="1605507" cy="2087970"/>
            </a:xfrm>
          </p:grpSpPr>
          <p:sp>
            <p:nvSpPr>
              <p:cNvPr id="102" name="CasellaDiTesto 31"/>
              <p:cNvSpPr txBox="1"/>
              <p:nvPr/>
            </p:nvSpPr>
            <p:spPr>
              <a:xfrm>
                <a:off x="5472100" y="2600908"/>
                <a:ext cx="990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>
                    <a:latin typeface="Arial" pitchFamily="34" charset="0"/>
                    <a:cs typeface="Arial" pitchFamily="34" charset="0"/>
                  </a:rPr>
                  <a:t>D</a:t>
                </a:r>
              </a:p>
            </p:txBody>
          </p:sp>
          <p:grpSp>
            <p:nvGrpSpPr>
              <p:cNvPr id="118" name="Gruppo 117"/>
              <p:cNvGrpSpPr/>
              <p:nvPr/>
            </p:nvGrpSpPr>
            <p:grpSpPr>
              <a:xfrm>
                <a:off x="5495719" y="2672916"/>
                <a:ext cx="1581888" cy="2015962"/>
                <a:chOff x="2786304" y="3106579"/>
                <a:chExt cx="1581888" cy="2015962"/>
              </a:xfrm>
            </p:grpSpPr>
            <p:grpSp>
              <p:nvGrpSpPr>
                <p:cNvPr id="119" name="Gruppo 118"/>
                <p:cNvGrpSpPr/>
                <p:nvPr/>
              </p:nvGrpSpPr>
              <p:grpSpPr>
                <a:xfrm>
                  <a:off x="3341706" y="3305142"/>
                  <a:ext cx="953386" cy="1817399"/>
                  <a:chOff x="914402" y="3346982"/>
                  <a:chExt cx="914398" cy="1258199"/>
                </a:xfrm>
              </p:grpSpPr>
              <p:sp>
                <p:nvSpPr>
                  <p:cNvPr id="123" name="CasellaDiTesto 122"/>
                  <p:cNvSpPr txBox="1"/>
                  <p:nvPr/>
                </p:nvSpPr>
                <p:spPr>
                  <a:xfrm rot="18643810">
                    <a:off x="841407" y="3903620"/>
                    <a:ext cx="1166971" cy="2361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000" b="1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itchFamily="34" charset="0"/>
                        <a:cs typeface="Arial" pitchFamily="34" charset="0"/>
                      </a:rPr>
                      <a:t>AdV_sh_</a:t>
                    </a:r>
                    <a:r>
                      <a:rPr lang="it-IT" sz="1000" b="1" cap="small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itchFamily="34" charset="0"/>
                        <a:cs typeface="Arial" pitchFamily="34" charset="0"/>
                      </a:rPr>
                      <a:t>Prune</a:t>
                    </a:r>
                    <a:endParaRPr lang="it-IT" sz="1000" b="1" cap="small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endParaRPr>
                  </a:p>
                </p:txBody>
              </p:sp>
              <p:sp>
                <p:nvSpPr>
                  <p:cNvPr id="124" name="CasellaDiTesto 123"/>
                  <p:cNvSpPr txBox="1"/>
                  <p:nvPr/>
                </p:nvSpPr>
                <p:spPr>
                  <a:xfrm rot="18643810">
                    <a:off x="716265" y="3951110"/>
                    <a:ext cx="779580" cy="23615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000" b="1" dirty="0" err="1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itchFamily="34" charset="0"/>
                        <a:cs typeface="Arial" pitchFamily="34" charset="0"/>
                      </a:rPr>
                      <a:t>AdV</a:t>
                    </a:r>
                    <a:r>
                      <a:rPr lang="it-IT" sz="1000" b="1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itchFamily="34" charset="0"/>
                        <a:cs typeface="Arial" pitchFamily="34" charset="0"/>
                      </a:rPr>
                      <a:t> </a:t>
                    </a:r>
                    <a:r>
                      <a:rPr lang="it-IT" sz="1000" b="1" dirty="0" err="1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itchFamily="34" charset="0"/>
                        <a:cs typeface="Arial" pitchFamily="34" charset="0"/>
                      </a:rPr>
                      <a:t>Mock</a:t>
                    </a:r>
                    <a:endParaRPr lang="it-IT" sz="1000" b="1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endParaRPr>
                  </a:p>
                </p:txBody>
              </p:sp>
              <p:pic>
                <p:nvPicPr>
                  <p:cNvPr id="125" name="Picture 7" descr="SH B-Actin (p-Ikba)926"/>
                  <p:cNvPicPr>
                    <a:picLocks noChangeArrowheads="1"/>
                  </p:cNvPicPr>
                  <p:nvPr/>
                </p:nvPicPr>
                <p:blipFill>
                  <a:blip r:embed="rId9" cstate="print"/>
                  <a:srcRect l="48285" t="13669" r="29424" b="10345"/>
                  <a:stretch>
                    <a:fillRect/>
                  </a:stretch>
                </p:blipFill>
                <p:spPr bwMode="auto">
                  <a:xfrm>
                    <a:off x="985650" y="3705839"/>
                    <a:ext cx="731520" cy="216000"/>
                  </a:xfrm>
                  <a:prstGeom prst="rect">
                    <a:avLst/>
                  </a:prstGeom>
                  <a:noFill/>
                </p:spPr>
              </p:pic>
              <p:pic>
                <p:nvPicPr>
                  <p:cNvPr id="126" name="Picture 9" descr="SH(mock-Cpp) Ikba Tot922"/>
                  <p:cNvPicPr>
                    <a:picLocks noChangeArrowheads="1"/>
                  </p:cNvPicPr>
                  <p:nvPr/>
                </p:nvPicPr>
                <p:blipFill>
                  <a:blip r:embed="rId10" cstate="print"/>
                  <a:srcRect l="49031" t="32433" r="31406" b="18919"/>
                  <a:stretch>
                    <a:fillRect/>
                  </a:stretch>
                </p:blipFill>
                <p:spPr bwMode="auto">
                  <a:xfrm>
                    <a:off x="985650" y="3459180"/>
                    <a:ext cx="731520" cy="216000"/>
                  </a:xfrm>
                  <a:prstGeom prst="rect">
                    <a:avLst/>
                  </a:prstGeom>
                  <a:noFill/>
                </p:spPr>
              </p:pic>
              <p:sp>
                <p:nvSpPr>
                  <p:cNvPr id="127" name="CasellaDiTesto 126"/>
                  <p:cNvSpPr txBox="1"/>
                  <p:nvPr/>
                </p:nvSpPr>
                <p:spPr>
                  <a:xfrm>
                    <a:off x="914402" y="3346982"/>
                    <a:ext cx="457201" cy="1385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700" dirty="0">
                        <a:latin typeface="Arial"/>
                        <a:cs typeface="Arial"/>
                      </a:rPr>
                      <a:t>1</a:t>
                    </a:r>
                  </a:p>
                </p:txBody>
              </p:sp>
              <p:sp>
                <p:nvSpPr>
                  <p:cNvPr id="128" name="CasellaDiTesto 127"/>
                  <p:cNvSpPr txBox="1"/>
                  <p:nvPr/>
                </p:nvSpPr>
                <p:spPr>
                  <a:xfrm>
                    <a:off x="1371599" y="3346982"/>
                    <a:ext cx="457201" cy="1385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700" dirty="0">
                        <a:latin typeface="Arial"/>
                        <a:cs typeface="Arial"/>
                      </a:rPr>
                      <a:t>0.6</a:t>
                    </a:r>
                  </a:p>
                </p:txBody>
              </p:sp>
            </p:grpSp>
            <p:sp>
              <p:nvSpPr>
                <p:cNvPr id="120" name="CasellaDiTesto 47"/>
                <p:cNvSpPr txBox="1"/>
                <p:nvPr/>
              </p:nvSpPr>
              <p:spPr>
                <a:xfrm>
                  <a:off x="2786304" y="3835399"/>
                  <a:ext cx="62624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000" b="1" dirty="0">
                      <a:latin typeface="Arial"/>
                      <a:cs typeface="Arial"/>
                    </a:rPr>
                    <a:t>β</a:t>
                  </a:r>
                  <a:r>
                    <a:rPr lang="it-IT" sz="1000" b="1" dirty="0">
                      <a:latin typeface="Arial"/>
                      <a:cs typeface="Arial"/>
                    </a:rPr>
                    <a:t>-Actin</a:t>
                  </a:r>
                </a:p>
              </p:txBody>
            </p:sp>
            <p:sp>
              <p:nvSpPr>
                <p:cNvPr id="121" name="CasellaDiTesto 50"/>
                <p:cNvSpPr txBox="1"/>
                <p:nvPr/>
              </p:nvSpPr>
              <p:spPr>
                <a:xfrm>
                  <a:off x="2870697" y="3505200"/>
                  <a:ext cx="55976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cap="small" dirty="0">
                      <a:latin typeface="Arial"/>
                      <a:cs typeface="Arial"/>
                    </a:rPr>
                    <a:t>Prune</a:t>
                  </a:r>
                </a:p>
              </p:txBody>
            </p:sp>
            <p:sp>
              <p:nvSpPr>
                <p:cNvPr id="122" name="TextBox 1"/>
                <p:cNvSpPr txBox="1"/>
                <p:nvPr/>
              </p:nvSpPr>
              <p:spPr>
                <a:xfrm>
                  <a:off x="3434020" y="3106579"/>
                  <a:ext cx="93417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SHSY5Y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132" name="Gruppo 131"/>
            <p:cNvGrpSpPr/>
            <p:nvPr/>
          </p:nvGrpSpPr>
          <p:grpSpPr>
            <a:xfrm>
              <a:off x="5976156" y="2800329"/>
              <a:ext cx="2808312" cy="1301714"/>
              <a:chOff x="11088" y="6394487"/>
              <a:chExt cx="2808312" cy="1301714"/>
            </a:xfrm>
          </p:grpSpPr>
          <p:sp>
            <p:nvSpPr>
              <p:cNvPr id="133" name="CasellaDiTesto 132"/>
              <p:cNvSpPr txBox="1"/>
              <p:nvPr/>
            </p:nvSpPr>
            <p:spPr>
              <a:xfrm>
                <a:off x="11088" y="6394487"/>
                <a:ext cx="6286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>
                    <a:latin typeface="Arial"/>
                    <a:cs typeface="Arial"/>
                  </a:rPr>
                  <a:t>E</a:t>
                </a:r>
              </a:p>
            </p:txBody>
          </p:sp>
          <p:grpSp>
            <p:nvGrpSpPr>
              <p:cNvPr id="134" name="Gruppo 133"/>
              <p:cNvGrpSpPr/>
              <p:nvPr/>
            </p:nvGrpSpPr>
            <p:grpSpPr>
              <a:xfrm>
                <a:off x="457200" y="6553201"/>
                <a:ext cx="2362200" cy="1143000"/>
                <a:chOff x="830718" y="3109208"/>
                <a:chExt cx="3389438" cy="1091644"/>
              </a:xfrm>
            </p:grpSpPr>
            <p:sp>
              <p:nvSpPr>
                <p:cNvPr id="135" name="CasellaDiTesto 39"/>
                <p:cNvSpPr txBox="1"/>
                <p:nvPr/>
              </p:nvSpPr>
              <p:spPr>
                <a:xfrm>
                  <a:off x="1532598" y="4025064"/>
                  <a:ext cx="984617" cy="1757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b="1" dirty="0">
                      <a:latin typeface="Arial" pitchFamily="34" charset="0"/>
                      <a:cs typeface="Arial" pitchFamily="34" charset="0"/>
                    </a:rPr>
                    <a:t>HEK-293</a:t>
                  </a:r>
                </a:p>
              </p:txBody>
            </p:sp>
            <p:sp>
              <p:nvSpPr>
                <p:cNvPr id="136" name="CasellaDiTesto 41"/>
                <p:cNvSpPr txBox="1"/>
                <p:nvPr/>
              </p:nvSpPr>
              <p:spPr>
                <a:xfrm>
                  <a:off x="1306971" y="3109208"/>
                  <a:ext cx="485720" cy="1757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b="1" dirty="0">
                      <a:latin typeface="Arial" pitchFamily="34" charset="0"/>
                      <a:cs typeface="Arial" pitchFamily="34" charset="0"/>
                    </a:rPr>
                    <a:t>EV</a:t>
                  </a:r>
                </a:p>
              </p:txBody>
            </p:sp>
            <p:sp>
              <p:nvSpPr>
                <p:cNvPr id="137" name="CasellaDiTesto 42"/>
                <p:cNvSpPr txBox="1"/>
                <p:nvPr/>
              </p:nvSpPr>
              <p:spPr>
                <a:xfrm>
                  <a:off x="1791597" y="3109208"/>
                  <a:ext cx="462313" cy="1757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b="1" dirty="0">
                      <a:latin typeface="Arial" pitchFamily="34" charset="0"/>
                      <a:cs typeface="Arial" pitchFamily="34" charset="0"/>
                    </a:rPr>
                    <a:t>FL</a:t>
                  </a:r>
                </a:p>
              </p:txBody>
            </p:sp>
            <p:sp>
              <p:nvSpPr>
                <p:cNvPr id="138" name="CasellaDiTesto 43"/>
                <p:cNvSpPr txBox="1"/>
                <p:nvPr/>
              </p:nvSpPr>
              <p:spPr>
                <a:xfrm>
                  <a:off x="2033422" y="3109208"/>
                  <a:ext cx="705230" cy="1757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b="1" dirty="0">
                      <a:latin typeface="Arial" pitchFamily="34" charset="0"/>
                      <a:cs typeface="Arial" pitchFamily="34" charset="0"/>
                    </a:rPr>
                    <a:t>D30N</a:t>
                  </a:r>
                </a:p>
              </p:txBody>
            </p:sp>
            <p:sp>
              <p:nvSpPr>
                <p:cNvPr id="139" name="CasellaDiTesto 44"/>
                <p:cNvSpPr txBox="1"/>
                <p:nvPr/>
              </p:nvSpPr>
              <p:spPr>
                <a:xfrm>
                  <a:off x="2629502" y="3109208"/>
                  <a:ext cx="844880" cy="1757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b="1" dirty="0">
                      <a:latin typeface="Arial" pitchFamily="34" charset="0"/>
                      <a:cs typeface="Arial" pitchFamily="34" charset="0"/>
                    </a:rPr>
                    <a:t>R297W</a:t>
                  </a:r>
                </a:p>
              </p:txBody>
            </p:sp>
            <p:sp>
              <p:nvSpPr>
                <p:cNvPr id="140" name="CasellaDiTesto 45"/>
                <p:cNvSpPr txBox="1"/>
                <p:nvPr/>
              </p:nvSpPr>
              <p:spPr>
                <a:xfrm>
                  <a:off x="830718" y="3109208"/>
                  <a:ext cx="485602" cy="1757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b="1" dirty="0">
                      <a:latin typeface="Arial" pitchFamily="34" charset="0"/>
                      <a:cs typeface="Arial" pitchFamily="34" charset="0"/>
                    </a:rPr>
                    <a:t>NT</a:t>
                  </a:r>
                </a:p>
              </p:txBody>
            </p:sp>
            <p:sp>
              <p:nvSpPr>
                <p:cNvPr id="141" name="CasellaDiTesto 47"/>
                <p:cNvSpPr txBox="1"/>
                <p:nvPr/>
              </p:nvSpPr>
              <p:spPr>
                <a:xfrm>
                  <a:off x="3370718" y="3766432"/>
                  <a:ext cx="849438" cy="1757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050" b="1" dirty="0">
                      <a:latin typeface="Times New Roman"/>
                      <a:cs typeface="Times New Roman"/>
                    </a:rPr>
                    <a:t>β</a:t>
                  </a:r>
                  <a:r>
                    <a:rPr lang="it-IT" sz="1050" b="1" dirty="0">
                      <a:latin typeface="Times New Roman"/>
                      <a:cs typeface="Times New Roman"/>
                    </a:rPr>
                    <a:t>-</a:t>
                  </a:r>
                  <a:r>
                    <a:rPr lang="it-IT" sz="1050" b="1" dirty="0">
                      <a:latin typeface="Arial" pitchFamily="34" charset="0"/>
                      <a:cs typeface="Arial" pitchFamily="34" charset="0"/>
                    </a:rPr>
                    <a:t>Actin</a:t>
                  </a:r>
                </a:p>
              </p:txBody>
            </p:sp>
            <p:pic>
              <p:nvPicPr>
                <p:cNvPr id="142" name="Picture 3"/>
                <p:cNvPicPr>
                  <a:picLocks noChangeArrowheads="1"/>
                </p:cNvPicPr>
                <p:nvPr/>
              </p:nvPicPr>
              <p:blipFill>
                <a:blip r:embed="rId11" cstate="print"/>
                <a:srcRect l="58675" t="40039" r="1244" b="51172"/>
                <a:stretch>
                  <a:fillRect/>
                </a:stretch>
              </p:blipFill>
              <p:spPr bwMode="auto">
                <a:xfrm>
                  <a:off x="838200" y="3733800"/>
                  <a:ext cx="2400000" cy="27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43" name="Picture 3"/>
                <p:cNvPicPr>
                  <a:picLocks noChangeArrowheads="1"/>
                </p:cNvPicPr>
                <p:nvPr/>
              </p:nvPicPr>
              <p:blipFill>
                <a:blip r:embed="rId12" cstate="print"/>
                <a:srcRect l="37884" t="52735" r="33565" b="40429"/>
                <a:stretch>
                  <a:fillRect/>
                </a:stretch>
              </p:blipFill>
              <p:spPr bwMode="auto">
                <a:xfrm>
                  <a:off x="838200" y="3403885"/>
                  <a:ext cx="2400000" cy="27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44" name="CasellaDiTesto 50"/>
                <p:cNvSpPr txBox="1"/>
                <p:nvPr/>
              </p:nvSpPr>
              <p:spPr>
                <a:xfrm>
                  <a:off x="3370717" y="3480682"/>
                  <a:ext cx="734861" cy="1757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b="1" dirty="0">
                      <a:latin typeface="Arial" pitchFamily="34" charset="0"/>
                      <a:cs typeface="Arial" pitchFamily="34" charset="0"/>
                    </a:rPr>
                    <a:t>FLAG</a:t>
                  </a:r>
                </a:p>
              </p:txBody>
            </p:sp>
          </p:grpSp>
        </p:grpSp>
        <p:grpSp>
          <p:nvGrpSpPr>
            <p:cNvPr id="145" name="Gruppo 144"/>
            <p:cNvGrpSpPr/>
            <p:nvPr/>
          </p:nvGrpSpPr>
          <p:grpSpPr>
            <a:xfrm>
              <a:off x="2519773" y="4560059"/>
              <a:ext cx="4320484" cy="2297941"/>
              <a:chOff x="2761747" y="5943600"/>
              <a:chExt cx="4146523" cy="2895600"/>
            </a:xfrm>
          </p:grpSpPr>
          <p:graphicFrame>
            <p:nvGraphicFramePr>
              <p:cNvPr id="146" name="Grafico 14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01052978"/>
                  </p:ext>
                </p:extLst>
              </p:nvPr>
            </p:nvGraphicFramePr>
            <p:xfrm>
              <a:off x="3022070" y="5943600"/>
              <a:ext cx="3886200" cy="2895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sp>
            <p:nvSpPr>
              <p:cNvPr id="147" name="CasellaDiTesto 146"/>
              <p:cNvSpPr txBox="1"/>
              <p:nvPr/>
            </p:nvSpPr>
            <p:spPr>
              <a:xfrm>
                <a:off x="2761747" y="6019800"/>
                <a:ext cx="628650" cy="3325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>
                    <a:latin typeface="Arial"/>
                    <a:cs typeface="Arial"/>
                  </a:rPr>
                  <a:t>F</a:t>
                </a:r>
              </a:p>
            </p:txBody>
          </p:sp>
        </p:grpSp>
      </p:grpSp>
      <p:sp>
        <p:nvSpPr>
          <p:cNvPr id="148" name="CasellaDiTesto 147"/>
          <p:cNvSpPr txBox="1"/>
          <p:nvPr/>
        </p:nvSpPr>
        <p:spPr>
          <a:xfrm>
            <a:off x="431540" y="16816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it-IT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45446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323528" y="836712"/>
            <a:ext cx="7128792" cy="4788532"/>
            <a:chOff x="-150168" y="3886200"/>
            <a:chExt cx="6019800" cy="3995996"/>
          </a:xfrm>
        </p:grpSpPr>
        <p:pic>
          <p:nvPicPr>
            <p:cNvPr id="5" name="Immagine 3" descr="Image044Snapshot5.tif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859" r="23653" b="-12839"/>
            <a:stretch>
              <a:fillRect/>
            </a:stretch>
          </p:blipFill>
          <p:spPr bwMode="auto">
            <a:xfrm>
              <a:off x="1376569" y="6926009"/>
              <a:ext cx="758592" cy="956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Immagine 4" descr="Image044Snapshot2.tif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300" r="24117" b="11378"/>
            <a:stretch>
              <a:fillRect/>
            </a:stretch>
          </p:blipFill>
          <p:spPr bwMode="auto">
            <a:xfrm>
              <a:off x="1369231" y="4312493"/>
              <a:ext cx="758677" cy="8137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Immagine 5" descr="Image044Snapshot3.tif"/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732" r="24117" b="11377"/>
            <a:stretch>
              <a:fillRect/>
            </a:stretch>
          </p:blipFill>
          <p:spPr bwMode="auto">
            <a:xfrm>
              <a:off x="1366510" y="5183776"/>
              <a:ext cx="758592" cy="819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Immagine 6" descr="Image044Snapshot4.tif"/>
            <p:cNvPicPr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781" r="23885" b="11377"/>
            <a:stretch>
              <a:fillRect/>
            </a:stretch>
          </p:blipFill>
          <p:spPr bwMode="auto">
            <a:xfrm>
              <a:off x="1366510" y="6058092"/>
              <a:ext cx="758592" cy="819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Immagine 7" descr="Image012Snapshot8.tif"/>
            <p:cNvPicPr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98" r="21695" b="42545"/>
            <a:stretch>
              <a:fillRect/>
            </a:stretch>
          </p:blipFill>
          <p:spPr bwMode="auto">
            <a:xfrm>
              <a:off x="2173864" y="5175743"/>
              <a:ext cx="758593" cy="8196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Immagine 8" descr="Image012Snapshot9.tif"/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98" r="21695" b="42545"/>
            <a:stretch>
              <a:fillRect/>
            </a:stretch>
          </p:blipFill>
          <p:spPr bwMode="auto">
            <a:xfrm>
              <a:off x="2173864" y="6050058"/>
              <a:ext cx="758593" cy="8196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" name="Immagine 9" descr="Image012Snapshot7.tif"/>
            <p:cNvPicPr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51" r="21536" b="42545"/>
            <a:stretch>
              <a:fillRect/>
            </a:stretch>
          </p:blipFill>
          <p:spPr bwMode="auto">
            <a:xfrm>
              <a:off x="2164246" y="4319852"/>
              <a:ext cx="758678" cy="7989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" name="Immagine 10" descr="Image012Snapshot10.tif"/>
            <p:cNvPicPr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98" r="20882" b="41745"/>
            <a:stretch>
              <a:fillRect/>
            </a:stretch>
          </p:blipFill>
          <p:spPr bwMode="auto">
            <a:xfrm>
              <a:off x="2170197" y="6936369"/>
              <a:ext cx="758593" cy="8117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" name="Immagine 11" descr="Image040Snapshot3.tif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19" t="17726" r="14677" b="18051"/>
            <a:stretch>
              <a:fillRect/>
            </a:stretch>
          </p:blipFill>
          <p:spPr bwMode="auto">
            <a:xfrm>
              <a:off x="2985014" y="5173701"/>
              <a:ext cx="754811" cy="8196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" name="Immagine 12" descr="Image040Snapshot2.tif"/>
            <p:cNvPicPr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16" t="17726" r="14107" b="18051"/>
            <a:stretch>
              <a:fillRect/>
            </a:stretch>
          </p:blipFill>
          <p:spPr bwMode="auto">
            <a:xfrm>
              <a:off x="2983166" y="4309416"/>
              <a:ext cx="758593" cy="8197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Immagine 13" descr="Image040Snapshot4.tif"/>
            <p:cNvPicPr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19" t="17726" r="14098" b="18051"/>
            <a:stretch>
              <a:fillRect/>
            </a:stretch>
          </p:blipFill>
          <p:spPr bwMode="auto">
            <a:xfrm>
              <a:off x="2983124" y="6050059"/>
              <a:ext cx="758593" cy="8196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" name="Immagine 14" descr="Image040Snapshot5.tif"/>
            <p:cNvPicPr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17" t="17726" r="15308" b="18954"/>
            <a:stretch>
              <a:fillRect/>
            </a:stretch>
          </p:blipFill>
          <p:spPr bwMode="auto">
            <a:xfrm>
              <a:off x="2983124" y="6932407"/>
              <a:ext cx="758593" cy="8196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Immagine 15" descr="Image022Snapshot2.tif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651" r="51784" b="38023"/>
            <a:stretch>
              <a:fillRect/>
            </a:stretch>
          </p:blipFill>
          <p:spPr bwMode="auto">
            <a:xfrm>
              <a:off x="3793241" y="4308531"/>
              <a:ext cx="758677" cy="8216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" name="Immagine 16" descr="Image022Snapshot4.tif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095" r="52042" b="38023"/>
            <a:stretch>
              <a:fillRect/>
            </a:stretch>
          </p:blipFill>
          <p:spPr bwMode="auto">
            <a:xfrm>
              <a:off x="3791785" y="6050703"/>
              <a:ext cx="758592" cy="8184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Immagine 17" descr="Image022Snapshot3.tif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28" r="52042" b="38023"/>
            <a:stretch>
              <a:fillRect/>
            </a:stretch>
          </p:blipFill>
          <p:spPr bwMode="auto">
            <a:xfrm>
              <a:off x="3788354" y="5180094"/>
              <a:ext cx="758592" cy="810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Immagine 18" descr="Image022Snapshot5.tif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095" r="52042" b="38023"/>
            <a:stretch>
              <a:fillRect/>
            </a:stretch>
          </p:blipFill>
          <p:spPr bwMode="auto">
            <a:xfrm>
              <a:off x="3791785" y="6933051"/>
              <a:ext cx="758592" cy="8184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" name="Immagine 19" descr="Image025Snapshot3.tif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23" t="8881" r="2" b="10081"/>
            <a:stretch>
              <a:fillRect/>
            </a:stretch>
          </p:blipFill>
          <p:spPr bwMode="auto">
            <a:xfrm rot="16200000">
              <a:off x="4669742" y="4241362"/>
              <a:ext cx="824706" cy="9610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" name="Immagine 20" descr="Image025Snapshot4.tif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23" t="8881" b="10081"/>
            <a:stretch>
              <a:fillRect/>
            </a:stretch>
          </p:blipFill>
          <p:spPr bwMode="auto">
            <a:xfrm rot="16200000">
              <a:off x="4675192" y="5108060"/>
              <a:ext cx="819671" cy="955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4" name="Immagine 21" descr="Image025Snapshot5.tif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23" t="8881" b="10081"/>
            <a:stretch>
              <a:fillRect/>
            </a:stretch>
          </p:blipFill>
          <p:spPr bwMode="auto">
            <a:xfrm rot="16200000">
              <a:off x="4675192" y="5982375"/>
              <a:ext cx="819671" cy="955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5" name="Immagine 22" descr="Image025Snapshot6.tif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23" t="8881" b="10081"/>
            <a:stretch>
              <a:fillRect/>
            </a:stretch>
          </p:blipFill>
          <p:spPr bwMode="auto">
            <a:xfrm rot="16200000">
              <a:off x="4675192" y="6864724"/>
              <a:ext cx="819671" cy="955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6" name="CasellaDiTesto 11"/>
            <p:cNvSpPr txBox="1">
              <a:spLocks noChangeArrowheads="1"/>
            </p:cNvSpPr>
            <p:nvPr/>
          </p:nvSpPr>
          <p:spPr bwMode="auto">
            <a:xfrm>
              <a:off x="1353304" y="4102645"/>
              <a:ext cx="771461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900" b="1" dirty="0" err="1"/>
                <a:t>Prophase</a:t>
              </a:r>
              <a:endParaRPr lang="it-IT" sz="900" b="1" dirty="0"/>
            </a:p>
          </p:txBody>
        </p:sp>
        <p:sp>
          <p:nvSpPr>
            <p:cNvPr id="27" name="CasellaDiTesto 22"/>
            <p:cNvSpPr txBox="1">
              <a:spLocks noChangeArrowheads="1"/>
            </p:cNvSpPr>
            <p:nvPr/>
          </p:nvSpPr>
          <p:spPr bwMode="auto">
            <a:xfrm>
              <a:off x="2140089" y="4102645"/>
              <a:ext cx="778310" cy="21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900" b="1" dirty="0" err="1"/>
                <a:t>Metaphase</a:t>
              </a:r>
              <a:endParaRPr lang="it-IT" sz="900" b="1" dirty="0"/>
            </a:p>
          </p:txBody>
        </p:sp>
        <p:sp>
          <p:nvSpPr>
            <p:cNvPr id="28" name="CasellaDiTesto 27"/>
            <p:cNvSpPr txBox="1">
              <a:spLocks noChangeArrowheads="1"/>
            </p:cNvSpPr>
            <p:nvPr/>
          </p:nvSpPr>
          <p:spPr bwMode="auto">
            <a:xfrm>
              <a:off x="2926873" y="4102645"/>
              <a:ext cx="785159" cy="21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900" b="1" dirty="0" err="1"/>
                <a:t>Anaphase</a:t>
              </a:r>
              <a:r>
                <a:rPr lang="it-IT" sz="900" b="1" dirty="0"/>
                <a:t> </a:t>
              </a:r>
            </a:p>
          </p:txBody>
        </p:sp>
        <p:sp>
          <p:nvSpPr>
            <p:cNvPr id="29" name="CasellaDiTesto 43"/>
            <p:cNvSpPr txBox="1">
              <a:spLocks noChangeArrowheads="1"/>
            </p:cNvSpPr>
            <p:nvPr/>
          </p:nvSpPr>
          <p:spPr bwMode="auto">
            <a:xfrm>
              <a:off x="3752996" y="4102645"/>
              <a:ext cx="752668" cy="21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900" b="1" dirty="0" err="1"/>
                <a:t>Telophase</a:t>
              </a:r>
              <a:endParaRPr lang="it-IT" sz="900" b="1" dirty="0"/>
            </a:p>
          </p:txBody>
        </p:sp>
        <p:sp>
          <p:nvSpPr>
            <p:cNvPr id="30" name="CasellaDiTesto 49"/>
            <p:cNvSpPr txBox="1">
              <a:spLocks noChangeArrowheads="1"/>
            </p:cNvSpPr>
            <p:nvPr/>
          </p:nvSpPr>
          <p:spPr bwMode="auto">
            <a:xfrm>
              <a:off x="4579120" y="4102645"/>
              <a:ext cx="917978" cy="21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900" b="1" dirty="0" err="1"/>
                <a:t>Cytokinesis</a:t>
              </a:r>
              <a:endParaRPr lang="it-IT" sz="900" b="1" dirty="0"/>
            </a:p>
          </p:txBody>
        </p:sp>
        <p:cxnSp>
          <p:nvCxnSpPr>
            <p:cNvPr id="31" name="Connettore 1 30"/>
            <p:cNvCxnSpPr/>
            <p:nvPr/>
          </p:nvCxnSpPr>
          <p:spPr>
            <a:xfrm>
              <a:off x="1371600" y="4114800"/>
              <a:ext cx="4267200" cy="0"/>
            </a:xfrm>
            <a:prstGeom prst="line">
              <a:avLst/>
            </a:prstGeom>
            <a:ln w="6350" cmpd="sng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CasellaDiTesto 6"/>
            <p:cNvSpPr txBox="1">
              <a:spLocks noChangeArrowheads="1"/>
            </p:cNvSpPr>
            <p:nvPr/>
          </p:nvSpPr>
          <p:spPr bwMode="auto">
            <a:xfrm rot="5400000">
              <a:off x="5297016" y="5828184"/>
              <a:ext cx="9144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900" b="1" dirty="0"/>
                <a:t>HELA </a:t>
              </a:r>
              <a:r>
                <a:rPr lang="it-IT" sz="900" b="1" dirty="0" err="1"/>
                <a:t>cells</a:t>
              </a:r>
              <a:endParaRPr lang="it-IT" sz="900" b="1" dirty="0"/>
            </a:p>
          </p:txBody>
        </p:sp>
        <p:pic>
          <p:nvPicPr>
            <p:cNvPr id="33" name="Immagine 32" descr="Image048Snapshot All1.tif"/>
            <p:cNvPicPr>
              <a:picLocks noChangeAspect="1"/>
            </p:cNvPicPr>
            <p:nvPr/>
          </p:nvPicPr>
          <p:blipFill rotWithShape="1"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070" r="79964" b="51305"/>
            <a:stretch/>
          </p:blipFill>
          <p:spPr>
            <a:xfrm>
              <a:off x="539401" y="4312493"/>
              <a:ext cx="755999" cy="815902"/>
            </a:xfrm>
            <a:prstGeom prst="rect">
              <a:avLst/>
            </a:prstGeom>
          </p:spPr>
        </p:pic>
        <p:pic>
          <p:nvPicPr>
            <p:cNvPr id="34" name="Immagine 33" descr="Image048Snapshot All1.tif"/>
            <p:cNvPicPr>
              <a:picLocks noChangeAspect="1"/>
            </p:cNvPicPr>
            <p:nvPr/>
          </p:nvPicPr>
          <p:blipFill rotWithShape="1"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107" t="77480" r="31841"/>
            <a:stretch/>
          </p:blipFill>
          <p:spPr>
            <a:xfrm>
              <a:off x="533400" y="6934200"/>
              <a:ext cx="753599" cy="806119"/>
            </a:xfrm>
            <a:prstGeom prst="rect">
              <a:avLst/>
            </a:prstGeom>
          </p:spPr>
        </p:pic>
        <p:pic>
          <p:nvPicPr>
            <p:cNvPr id="35" name="Immagine 34" descr="Image048Snapshot All1.tif"/>
            <p:cNvPicPr>
              <a:picLocks noChangeAspect="1"/>
            </p:cNvPicPr>
            <p:nvPr/>
          </p:nvPicPr>
          <p:blipFill rotWithShape="1"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59000" contras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8674" r="79758"/>
            <a:stretch/>
          </p:blipFill>
          <p:spPr>
            <a:xfrm>
              <a:off x="533400" y="6081264"/>
              <a:ext cx="755999" cy="796518"/>
            </a:xfrm>
            <a:prstGeom prst="rect">
              <a:avLst/>
            </a:prstGeom>
          </p:spPr>
        </p:pic>
        <p:pic>
          <p:nvPicPr>
            <p:cNvPr id="36" name="Immagine 35" descr="Image048Snapshot All1.tif"/>
            <p:cNvPicPr>
              <a:picLocks noChangeAspect="1"/>
            </p:cNvPicPr>
            <p:nvPr/>
          </p:nvPicPr>
          <p:blipFill rotWithShape="1">
            <a:blip r:embed="rId28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69000" contrast="3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014" t="27208" r="30867" b="51231"/>
            <a:stretch/>
          </p:blipFill>
          <p:spPr>
            <a:xfrm>
              <a:off x="533400" y="5181600"/>
              <a:ext cx="755999" cy="810221"/>
            </a:xfrm>
            <a:prstGeom prst="rect">
              <a:avLst/>
            </a:prstGeom>
          </p:spPr>
        </p:pic>
        <p:sp>
          <p:nvSpPr>
            <p:cNvPr id="37" name="Rettangolo 36"/>
            <p:cNvSpPr/>
            <p:nvPr/>
          </p:nvSpPr>
          <p:spPr>
            <a:xfrm>
              <a:off x="-10460" y="6965564"/>
              <a:ext cx="52460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900" b="1" dirty="0">
                  <a:solidFill>
                    <a:srgbClr val="CC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38" name="Rettangolo 37"/>
            <p:cNvSpPr/>
            <p:nvPr/>
          </p:nvSpPr>
          <p:spPr>
            <a:xfrm>
              <a:off x="29546" y="6127364"/>
              <a:ext cx="484597" cy="2185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900" b="1" dirty="0">
                  <a:solidFill>
                    <a:srgbClr val="1C3E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raq5</a:t>
              </a:r>
            </a:p>
          </p:txBody>
        </p:sp>
        <p:sp>
          <p:nvSpPr>
            <p:cNvPr id="39" name="Rettangolo 38"/>
            <p:cNvSpPr/>
            <p:nvPr/>
          </p:nvSpPr>
          <p:spPr>
            <a:xfrm>
              <a:off x="-150168" y="5212964"/>
              <a:ext cx="664311" cy="2185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900" b="1" dirty="0">
                  <a:solidFill>
                    <a:srgbClr val="FE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it-IT" sz="900" b="1" dirty="0">
                  <a:solidFill>
                    <a:srgbClr val="FE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sp>
          <p:nvSpPr>
            <p:cNvPr id="40" name="Rettangolo 39"/>
            <p:cNvSpPr/>
            <p:nvPr/>
          </p:nvSpPr>
          <p:spPr>
            <a:xfrm>
              <a:off x="-28556" y="4374764"/>
              <a:ext cx="442909" cy="1926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900" b="1" cap="small" dirty="0">
                  <a:solidFill>
                    <a:srgbClr val="00BE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une</a:t>
              </a:r>
            </a:p>
          </p:txBody>
        </p:sp>
        <p:sp>
          <p:nvSpPr>
            <p:cNvPr id="41" name="CasellaDiTesto 11"/>
            <p:cNvSpPr txBox="1">
              <a:spLocks noChangeArrowheads="1"/>
            </p:cNvSpPr>
            <p:nvPr/>
          </p:nvSpPr>
          <p:spPr bwMode="auto">
            <a:xfrm>
              <a:off x="533400" y="4114800"/>
              <a:ext cx="771461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900" b="1" dirty="0" err="1"/>
                <a:t>Interphase</a:t>
              </a:r>
              <a:endParaRPr lang="it-IT" sz="900" b="1" dirty="0"/>
            </a:p>
          </p:txBody>
        </p:sp>
        <p:sp>
          <p:nvSpPr>
            <p:cNvPr id="42" name="CasellaDiTesto 22"/>
            <p:cNvSpPr txBox="1">
              <a:spLocks noChangeArrowheads="1"/>
            </p:cNvSpPr>
            <p:nvPr/>
          </p:nvSpPr>
          <p:spPr bwMode="auto">
            <a:xfrm>
              <a:off x="2743200" y="3886200"/>
              <a:ext cx="77831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900" b="1" dirty="0" err="1"/>
                <a:t>Mitosis</a:t>
              </a:r>
              <a:endParaRPr lang="it-IT" sz="900" b="1" dirty="0"/>
            </a:p>
          </p:txBody>
        </p:sp>
        <p:cxnSp>
          <p:nvCxnSpPr>
            <p:cNvPr id="43" name="Connettore 1 42"/>
            <p:cNvCxnSpPr/>
            <p:nvPr/>
          </p:nvCxnSpPr>
          <p:spPr>
            <a:xfrm flipV="1">
              <a:off x="5638800" y="4343400"/>
              <a:ext cx="0" cy="3429000"/>
            </a:xfrm>
            <a:prstGeom prst="line">
              <a:avLst/>
            </a:prstGeom>
            <a:ln w="6350" cmpd="sng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4" name="CasellaDiTesto 147"/>
          <p:cNvSpPr txBox="1"/>
          <p:nvPr/>
        </p:nvSpPr>
        <p:spPr>
          <a:xfrm>
            <a:off x="431540" y="16816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it-IT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73347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9512" y="97818"/>
            <a:ext cx="8245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Table 1: Clinical findings of individuals with </a:t>
            </a:r>
            <a:r>
              <a:rPr lang="en-GB" dirty="0" err="1"/>
              <a:t>biallelic</a:t>
            </a:r>
            <a:r>
              <a:rPr lang="en-GB" dirty="0"/>
              <a:t> </a:t>
            </a:r>
            <a:r>
              <a:rPr lang="en-GB" i="1" dirty="0"/>
              <a:t>PRUNE1</a:t>
            </a:r>
            <a:r>
              <a:rPr lang="en-GB" dirty="0"/>
              <a:t> mutation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19572" y="652230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/>
          </p:nvPr>
        </p:nvGraphicFramePr>
        <p:xfrm>
          <a:off x="35496" y="620688"/>
          <a:ext cx="9036491" cy="6084669"/>
        </p:xfrm>
        <a:graphic>
          <a:graphicData uri="http://schemas.openxmlformats.org/drawingml/2006/table">
            <a:tbl>
              <a:tblPr firstRow="1" firstCol="1" bandRow="1"/>
              <a:tblGrid>
                <a:gridCol w="81958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547794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</a:tblGrid>
              <a:tr h="193483">
                <a:tc>
                  <a:txBody>
                    <a:bodyPr/>
                    <a:lstStyle/>
                    <a:p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A-IV:I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A-V:I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A-V:6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A-V:11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B-VI:1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B-VI:2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B:VI:8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B-VI:9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B-VI:11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C-II:2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C-II:3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D-II:1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D-II:2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BAB3500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b="1" dirty="0">
                          <a:solidFill>
                            <a:srgbClr val="FFFF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BAB3737</a:t>
                      </a:r>
                      <a:endParaRPr lang="en-GB" sz="550" b="1" dirty="0">
                        <a:solidFill>
                          <a:srgbClr val="FFFF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>
                      <a:noFill/>
                    </a:lnL>
                    <a:lnR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29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RUNE MUTATION (protein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sp30Asn/ Asp30As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sp30Asn/ Asp30As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sp30Asn/ Asp30As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sp30Asn/ Asp30As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54Thr/ Pro54Thr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54Thr/ Pro54Thr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54Thr/ Pro54Thr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54Thr/ Pro54Thr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54Thr/ Pro54Thr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Asp106As/ Asp106Asn</a:t>
                      </a: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Asp106Asn/ Asp106Asn</a:t>
                      </a: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rg297Trp/ Arg297Trp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rg297Trp/ Arg297Trp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sp106Asn/ Asp106As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sp106Asn/Asp106As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4472C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GENDER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M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M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M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423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GE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(at evaluation, YRS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0.3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2.1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10.6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5.0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4.0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6.0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14.0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21.0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4.0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3.7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5.5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1.5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.5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5.5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GROWTH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2820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Birth weight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kg (SDS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1.6 at 36/40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(-2.9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2.5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(-2.5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1.6 at 39/40 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(-4.0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2.9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(-1.1)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3.1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(-1.0)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3.85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(0.96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694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OFC cm (SDS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37 (-4.6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7 (-2.6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49 (-3.9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4.5 (-6.0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7 (-3.4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46 (-5.2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47 (-5.9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7 (-6.1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45 (-5.1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46</a:t>
                      </a:r>
                      <a:r>
                        <a:rPr lang="en-GB" sz="550" baseline="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 (-4.1)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47 (-3.6)</a:t>
                      </a: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48 (-3.3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44 (-3.4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microcephaly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microcephaly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694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Plagiocephaly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n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n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1766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Height</a:t>
                      </a:r>
                      <a:r>
                        <a:rPr lang="it-IT" sz="550" b="1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cm (SDS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81.7 (-1.9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93 (-2.1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102 (-2.8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129 (-4.7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137 (-4.4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83 (-4.6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92 (-1.9)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n/k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94 (-3.3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76 (-1.6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Weight kg (SDS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3.4 (-5.6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7.21 (-5.5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n/k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n/k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9.2 (-7.9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6.8 (-4.6)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DEVELOPMENT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Non verbal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2820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o independent ambulatio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2820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Intellectual disability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Profound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Profound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Profound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EYES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22820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ongenital cataracts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(unilateral)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(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unilateral)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22820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b="1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Optic</a:t>
                      </a:r>
                      <a:r>
                        <a:rPr lang="it-IT" sz="550" b="1" i="1" baseline="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b="1" i="1" baseline="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atrophy</a:t>
                      </a:r>
                      <a:endParaRPr lang="it-IT" sz="550" b="1" i="1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n/k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n/k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NEUROLOGY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Seizures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-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uscle wasting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Central hypotonia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22820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Spastic quadriparesis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>
                          <a:effectLst/>
                          <a:latin typeface="Arial"/>
                          <a:ea typeface="Calibri"/>
                          <a:cs typeface="Times New Roman"/>
                        </a:rPr>
                        <a:t>Hyperreflexia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+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+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+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+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+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1694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ontractures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5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 2" panose="05020102010507070707" pitchFamily="18" charset="2"/>
                        </a:rPr>
                        <a:t>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Arial"/>
                          <a:sym typeface="Wingdings 2"/>
                        </a:rPr>
                        <a:t>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k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  <a:tr h="11410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b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EUROIMAGING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55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55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0"/>
                  </a:ext>
                </a:extLst>
              </a:tr>
              <a:tr h="1026938">
                <a:tc>
                  <a:txBody>
                    <a:bodyPr/>
                    <a:lstStyle/>
                    <a:p>
                      <a:endParaRPr lang="en-GB" sz="550" dirty="0">
                        <a:effectLst/>
                        <a:latin typeface="Calibri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Wide spread white </a:t>
                      </a:r>
                      <a:r>
                        <a:rPr lang="it-IT" sz="55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matter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it-IT" sz="55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hypodensity</a:t>
                      </a:r>
                      <a:endParaRPr lang="it-IT" sz="550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 err="1">
                          <a:effectLst/>
                          <a:latin typeface="Arial"/>
                          <a:ea typeface="Calibri"/>
                          <a:cs typeface="Times New Roman"/>
                        </a:rPr>
                        <a:t>Thin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corpus callosum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a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a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T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Wide spread white matter hypodensity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ild Cerebral Atrophy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hin corpus callosum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Delayed myelinatio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 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Delayed myelinatio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 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Delayed myelinatio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 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Delayed myelinatio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 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Delayed myelinatio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MRI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Cerebral and cerebellar atrophy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Diffuse white matter</a:t>
                      </a:r>
                      <a:r>
                        <a:rPr lang="en-GB" sz="550" baseline="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 abnormalities</a:t>
                      </a: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 </a:t>
                      </a:r>
                      <a:endParaRPr lang="en-GB" sz="55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Cerebral and cerebellar atrophy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Diffuse white matter abnormalities</a:t>
                      </a: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on</a:t>
                      </a:r>
                      <a:r>
                        <a:rPr lang="it-IT" sz="550" baseline="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specific focal signal changes in parietal white matter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n/a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 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b="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ortical atrophy</a:t>
                      </a:r>
                      <a:endParaRPr lang="en-GB" sz="550" b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erebral Atrophy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hin corpus callosum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Delayed myelinatio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RI 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50" b="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ortical atrophy</a:t>
                      </a:r>
                      <a:endParaRPr lang="en-GB" sz="550" b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Cerebral Atrophy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hin corpus callosum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55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Delayed myelination</a:t>
                      </a:r>
                      <a:endParaRPr lang="en-GB" sz="55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722" marR="63722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989526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69243" y="288392"/>
            <a:ext cx="2424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Table  2</a:t>
            </a:r>
          </a:p>
        </p:txBody>
      </p:sp>
      <p:graphicFrame>
        <p:nvGraphicFramePr>
          <p:cNvPr id="4" name="Ogget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3672681"/>
              </p:ext>
            </p:extLst>
          </p:nvPr>
        </p:nvGraphicFramePr>
        <p:xfrm>
          <a:off x="788988" y="1912938"/>
          <a:ext cx="8302625" cy="142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7" name="Document" r:id="rId4" imgW="6213789" imgH="1071442" progId="Word.Document.12">
                  <p:embed/>
                </p:oleObj>
              </mc:Choice>
              <mc:Fallback>
                <p:oleObj name="Document" r:id="rId4" imgW="6213789" imgH="1071442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88988" y="1912938"/>
                        <a:ext cx="8302625" cy="142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ttangolo 4"/>
          <p:cNvSpPr/>
          <p:nvPr/>
        </p:nvSpPr>
        <p:spPr>
          <a:xfrm>
            <a:off x="359532" y="3501008"/>
            <a:ext cx="703327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it-IT" sz="1000" dirty="0">
                <a:latin typeface="Arial"/>
                <a:cs typeface="Arial"/>
              </a:rPr>
              <a:t>Table showing the kinetic parameters (K</a:t>
            </a:r>
            <a:r>
              <a:rPr lang="it-IT" sz="1000" baseline="-25000" dirty="0">
                <a:latin typeface="Arial"/>
                <a:cs typeface="Arial"/>
              </a:rPr>
              <a:t>m</a:t>
            </a:r>
            <a:r>
              <a:rPr lang="it-IT" sz="1000" dirty="0">
                <a:latin typeface="Arial"/>
                <a:cs typeface="Arial"/>
              </a:rPr>
              <a:t>, K</a:t>
            </a:r>
            <a:r>
              <a:rPr lang="it-IT" sz="1000" baseline="-25000" dirty="0">
                <a:latin typeface="Arial"/>
                <a:cs typeface="Arial"/>
              </a:rPr>
              <a:t>cat</a:t>
            </a:r>
            <a:r>
              <a:rPr lang="it-IT" sz="1000" dirty="0">
                <a:latin typeface="Arial"/>
                <a:cs typeface="Arial"/>
              </a:rPr>
              <a:t>, K</a:t>
            </a:r>
            <a:r>
              <a:rPr lang="it-IT" sz="1000" baseline="-25000" dirty="0">
                <a:latin typeface="Arial"/>
                <a:cs typeface="Arial"/>
              </a:rPr>
              <a:t>cat</a:t>
            </a:r>
            <a:r>
              <a:rPr lang="it-IT" sz="1000" dirty="0">
                <a:latin typeface="Arial"/>
                <a:cs typeface="Arial"/>
              </a:rPr>
              <a:t>/K</a:t>
            </a:r>
            <a:r>
              <a:rPr lang="it-IT" sz="1000" baseline="-25000" dirty="0">
                <a:latin typeface="Arial"/>
                <a:cs typeface="Arial"/>
              </a:rPr>
              <a:t>m</a:t>
            </a:r>
            <a:r>
              <a:rPr lang="it-IT" sz="1000" dirty="0">
                <a:latin typeface="Arial"/>
                <a:cs typeface="Arial"/>
              </a:rPr>
              <a:t>) from the biochemical activity of either </a:t>
            </a:r>
            <a:r>
              <a:rPr lang="it-IT" sz="1000" cap="small" dirty="0">
                <a:latin typeface="Arial"/>
                <a:cs typeface="Arial"/>
              </a:rPr>
              <a:t>Prune</a:t>
            </a:r>
            <a:r>
              <a:rPr lang="it-IT" sz="1000" dirty="0">
                <a:latin typeface="Arial"/>
                <a:cs typeface="Arial"/>
              </a:rPr>
              <a:t> wild-type (grey), D30N (orange) and R297W (green) mutated proteins on P4-tetraphosphates. As demonstrated both mutated proteins show increased PPase-activity compared to </a:t>
            </a:r>
            <a:r>
              <a:rPr lang="it-IT" sz="1000" cap="small" dirty="0" smtClean="0">
                <a:latin typeface="Arial"/>
                <a:cs typeface="Arial"/>
              </a:rPr>
              <a:t>Prune</a:t>
            </a:r>
            <a:r>
              <a:rPr lang="it-IT" sz="1000" dirty="0" smtClean="0">
                <a:latin typeface="Arial"/>
                <a:cs typeface="Arial"/>
              </a:rPr>
              <a:t> wild-type </a:t>
            </a:r>
            <a:r>
              <a:rPr lang="it-IT" sz="1000" dirty="0">
                <a:latin typeface="Arial"/>
                <a:cs typeface="Arial"/>
              </a:rPr>
              <a:t>protein (grey).</a:t>
            </a:r>
          </a:p>
        </p:txBody>
      </p:sp>
    </p:spTree>
    <p:extLst>
      <p:ext uri="{BB962C8B-B14F-4D97-AF65-F5344CB8AC3E}">
        <p14:creationId xmlns:p14="http://schemas.microsoft.com/office/powerpoint/2010/main" val="3717713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9495487"/>
              </p:ext>
            </p:extLst>
          </p:nvPr>
        </p:nvGraphicFramePr>
        <p:xfrm>
          <a:off x="104774" y="1135063"/>
          <a:ext cx="8031621" cy="5686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0" name="Document" r:id="rId4" imgW="5535439" imgH="3931403" progId="Word.Document.12">
                  <p:embed/>
                </p:oleObj>
              </mc:Choice>
              <mc:Fallback>
                <p:oleObj name="Document" r:id="rId4" imgW="5535439" imgH="3931403" progId="Word.Document.12">
                  <p:embed/>
                  <p:pic>
                    <p:nvPicPr>
                      <p:cNvPr id="0" name="Oggetto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4774" y="1135063"/>
                        <a:ext cx="8031621" cy="5686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mc:AlternateContent xmlns:mc="http://schemas.openxmlformats.org/markup-compatibility/2006" xmlns:a14="http://schemas.microsoft.com/office/drawing/2010/main">
        <mc:Choice Requires="a14">
          <p:sp>
            <p:nvSpPr>
              <p:cNvPr id="3" name="TextBox 2"/>
              <p:cNvSpPr txBox="1"/>
              <p:nvPr/>
            </p:nvSpPr>
            <p:spPr>
              <a:xfrm>
                <a:off x="369243" y="288392"/>
                <a:ext cx="8353505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Supplementary Table  3. SHSY5Y inducible cells expressing wild type, D30N and R297W </a:t>
                </a:r>
              </a:p>
              <a:p>
                <a:r>
                  <a:rPr lang="en-GB" dirty="0" smtClean="0"/>
                  <a:t>PRUNE with aster diameter &gt;5</a:t>
                </a:r>
                <a14:m>
                  <m:oMath xmlns:m="http://schemas.openxmlformats.org/officeDocument/2006/math">
                    <m:r>
                      <a:rPr lang="en-GB" i="1" smtClean="0">
                        <a:latin typeface="Cambria Math"/>
                      </a:rPr>
                      <m:t>µ</m:t>
                    </m:r>
                  </m:oMath>
                </a14:m>
                <a:r>
                  <a:rPr lang="en-GB" dirty="0"/>
                  <a:t>m</a:t>
                </a:r>
                <a:r>
                  <a:rPr lang="en-GB" dirty="0" smtClean="0"/>
                  <a:t>.</a:t>
                </a:r>
                <a:endParaRPr lang="en-GB" dirty="0"/>
              </a:p>
            </p:txBody>
          </p:sp>
        </mc:Choice>
        <mc:Fallback xmlns="">
          <p:sp>
            <p:nvSpPr>
              <p:cNvPr id="3" name="TextBox 2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69243" y="288392"/>
                <a:ext cx="8353505" cy="646331"/>
              </a:xfrm>
              <a:prstGeom prst="rect">
                <a:avLst/>
              </a:prstGeom>
              <a:blipFill rotWithShape="0">
                <a:blip r:embed="rId6"/>
                <a:stretch>
                  <a:fillRect l="-657" t="-4717" b="-14151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20848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522</TotalTime>
  <Words>804</Words>
  <Application>Microsoft Office PowerPoint</Application>
  <PresentationFormat>On-screen Show (4:3)</PresentationFormat>
  <Paragraphs>614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ＭＳ Ｐゴシック</vt:lpstr>
      <vt:lpstr>Arial</vt:lpstr>
      <vt:lpstr>Calibri</vt:lpstr>
      <vt:lpstr>Cambria Math</vt:lpstr>
      <vt:lpstr>Times New Roman</vt:lpstr>
      <vt:lpstr>Wingdings 2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ed, Mustafa</dc:creator>
  <cp:lastModifiedBy>Harlalka, Gaurav</cp:lastModifiedBy>
  <cp:revision>413</cp:revision>
  <dcterms:created xsi:type="dcterms:W3CDTF">2006-08-16T00:00:00Z</dcterms:created>
  <dcterms:modified xsi:type="dcterms:W3CDTF">2017-02-17T12:01:01Z</dcterms:modified>
</cp:coreProperties>
</file>